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76" r:id="rId5"/>
    <p:sldId id="270" r:id="rId6"/>
    <p:sldId id="257" r:id="rId7"/>
    <p:sldId id="263" r:id="rId8"/>
    <p:sldId id="261" r:id="rId9"/>
    <p:sldId id="272" r:id="rId10"/>
    <p:sldId id="277" r:id="rId11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ujanovic, Nikola" initials="VN" lastIdx="5" clrIdx="0">
    <p:extLst>
      <p:ext uri="{19B8F6BF-5375-455C-9EA6-DF929625EA0E}">
        <p15:presenceInfo xmlns:p15="http://schemas.microsoft.com/office/powerpoint/2012/main" userId="Vujanovic, Nikol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CC"/>
    <a:srgbClr val="FF7C80"/>
    <a:srgbClr val="FF5050"/>
    <a:srgbClr val="99CCFF"/>
    <a:srgbClr val="99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63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3006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commentAuthors" Target="commentAuthors.xml"/><Relationship Id="rId17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ujanovic, Lazar Nikola" userId="395234ee-677e-45c2-bf71-d39fe868b890" providerId="ADAL" clId="{5856BD29-57E3-461A-8EA3-9CCC9889096A}"/>
    <pc:docChg chg="custSel addSld modSld">
      <pc:chgData name="Vujanovic, Lazar Nikola" userId="395234ee-677e-45c2-bf71-d39fe868b890" providerId="ADAL" clId="{5856BD29-57E3-461A-8EA3-9CCC9889096A}" dt="2022-07-14T00:19:16.534" v="554" actId="20577"/>
      <pc:docMkLst>
        <pc:docMk/>
      </pc:docMkLst>
      <pc:sldChg chg="modSp mod">
        <pc:chgData name="Vujanovic, Lazar Nikola" userId="395234ee-677e-45c2-bf71-d39fe868b890" providerId="ADAL" clId="{5856BD29-57E3-461A-8EA3-9CCC9889096A}" dt="2022-07-12T15:47:45.164" v="455" actId="114"/>
        <pc:sldMkLst>
          <pc:docMk/>
          <pc:sldMk cId="3225534328" sldId="257"/>
        </pc:sldMkLst>
        <pc:spChg chg="mod">
          <ac:chgData name="Vujanovic, Lazar Nikola" userId="395234ee-677e-45c2-bf71-d39fe868b890" providerId="ADAL" clId="{5856BD29-57E3-461A-8EA3-9CCC9889096A}" dt="2022-07-12T15:47:45.164" v="455" actId="114"/>
          <ac:spMkLst>
            <pc:docMk/>
            <pc:sldMk cId="3225534328" sldId="257"/>
            <ac:spMk id="12" creationId="{703A0EA3-1B7E-415F-8527-FC6FC45EE7E2}"/>
          </ac:spMkLst>
        </pc:spChg>
      </pc:sldChg>
      <pc:sldChg chg="addSp delSp modSp mod">
        <pc:chgData name="Vujanovic, Lazar Nikola" userId="395234ee-677e-45c2-bf71-d39fe868b890" providerId="ADAL" clId="{5856BD29-57E3-461A-8EA3-9CCC9889096A}" dt="2022-07-13T23:41:13.193" v="549" actId="478"/>
        <pc:sldMkLst>
          <pc:docMk/>
          <pc:sldMk cId="2634600653" sldId="270"/>
        </pc:sldMkLst>
        <pc:spChg chg="mod">
          <ac:chgData name="Vujanovic, Lazar Nikola" userId="395234ee-677e-45c2-bf71-d39fe868b890" providerId="ADAL" clId="{5856BD29-57E3-461A-8EA3-9CCC9889096A}" dt="2022-07-13T23:40:23.189" v="499" actId="1035"/>
          <ac:spMkLst>
            <pc:docMk/>
            <pc:sldMk cId="2634600653" sldId="270"/>
            <ac:spMk id="3" creationId="{1CEF565C-FF71-4CCF-91A1-BAEAE3857D13}"/>
          </ac:spMkLst>
        </pc:spChg>
        <pc:graphicFrameChg chg="mod">
          <ac:chgData name="Vujanovic, Lazar Nikola" userId="395234ee-677e-45c2-bf71-d39fe868b890" providerId="ADAL" clId="{5856BD29-57E3-461A-8EA3-9CCC9889096A}" dt="2022-07-13T23:40:12.595" v="456" actId="12789"/>
          <ac:graphicFrameMkLst>
            <pc:docMk/>
            <pc:sldMk cId="2634600653" sldId="270"/>
            <ac:graphicFrameMk id="6" creationId="{640A0241-DE6C-4B95-AC6E-142230BA6020}"/>
          </ac:graphicFrameMkLst>
        </pc:graphicFrameChg>
        <pc:cxnChg chg="add del mod">
          <ac:chgData name="Vujanovic, Lazar Nikola" userId="395234ee-677e-45c2-bf71-d39fe868b890" providerId="ADAL" clId="{5856BD29-57E3-461A-8EA3-9CCC9889096A}" dt="2022-07-13T23:41:13.193" v="549" actId="478"/>
          <ac:cxnSpMkLst>
            <pc:docMk/>
            <pc:sldMk cId="2634600653" sldId="270"/>
            <ac:cxnSpMk id="4" creationId="{AFC44EC8-5E2A-995B-5993-EE84C47A6498}"/>
          </ac:cxnSpMkLst>
        </pc:cxnChg>
      </pc:sldChg>
      <pc:sldChg chg="delSp mod">
        <pc:chgData name="Vujanovic, Lazar Nikola" userId="395234ee-677e-45c2-bf71-d39fe868b890" providerId="ADAL" clId="{5856BD29-57E3-461A-8EA3-9CCC9889096A}" dt="2022-07-12T15:38:43.826" v="2" actId="478"/>
        <pc:sldMkLst>
          <pc:docMk/>
          <pc:sldMk cId="2173377607" sldId="272"/>
        </pc:sldMkLst>
        <pc:spChg chg="del">
          <ac:chgData name="Vujanovic, Lazar Nikola" userId="395234ee-677e-45c2-bf71-d39fe868b890" providerId="ADAL" clId="{5856BD29-57E3-461A-8EA3-9CCC9889096A}" dt="2022-07-12T15:38:43.826" v="2" actId="478"/>
          <ac:spMkLst>
            <pc:docMk/>
            <pc:sldMk cId="2173377607" sldId="272"/>
            <ac:spMk id="2" creationId="{0E177EA3-1C8F-4122-B14C-7FFF7B5757DA}"/>
          </ac:spMkLst>
        </pc:spChg>
      </pc:sldChg>
      <pc:sldChg chg="addSp delSp modSp mod">
        <pc:chgData name="Vujanovic, Lazar Nikola" userId="395234ee-677e-45c2-bf71-d39fe868b890" providerId="ADAL" clId="{5856BD29-57E3-461A-8EA3-9CCC9889096A}" dt="2022-07-13T23:41:03.078" v="547" actId="21"/>
        <pc:sldMkLst>
          <pc:docMk/>
          <pc:sldMk cId="3791221629" sldId="276"/>
        </pc:sldMkLst>
        <pc:spChg chg="mod">
          <ac:chgData name="Vujanovic, Lazar Nikola" userId="395234ee-677e-45c2-bf71-d39fe868b890" providerId="ADAL" clId="{5856BD29-57E3-461A-8EA3-9CCC9889096A}" dt="2022-07-13T23:40:54.418" v="546" actId="1036"/>
          <ac:spMkLst>
            <pc:docMk/>
            <pc:sldMk cId="3791221629" sldId="276"/>
            <ac:spMk id="6" creationId="{8169A85E-FAA9-4D7D-888A-87444D776F51}"/>
          </ac:spMkLst>
        </pc:spChg>
        <pc:spChg chg="mod">
          <ac:chgData name="Vujanovic, Lazar Nikola" userId="395234ee-677e-45c2-bf71-d39fe868b890" providerId="ADAL" clId="{5856BD29-57E3-461A-8EA3-9CCC9889096A}" dt="2022-07-13T23:40:54.418" v="546" actId="1036"/>
          <ac:spMkLst>
            <pc:docMk/>
            <pc:sldMk cId="3791221629" sldId="276"/>
            <ac:spMk id="8" creationId="{4C844E56-A648-43E9-AE9B-B23BB1012533}"/>
          </ac:spMkLst>
        </pc:spChg>
        <pc:graphicFrameChg chg="mod">
          <ac:chgData name="Vujanovic, Lazar Nikola" userId="395234ee-677e-45c2-bf71-d39fe868b890" providerId="ADAL" clId="{5856BD29-57E3-461A-8EA3-9CCC9889096A}" dt="2022-07-13T23:40:54.418" v="546" actId="1036"/>
          <ac:graphicFrameMkLst>
            <pc:docMk/>
            <pc:sldMk cId="3791221629" sldId="276"/>
            <ac:graphicFrameMk id="3" creationId="{9007C350-3D30-4932-AE02-1FB7A951D317}"/>
          </ac:graphicFrameMkLst>
        </pc:graphicFrameChg>
        <pc:cxnChg chg="add del mod">
          <ac:chgData name="Vujanovic, Lazar Nikola" userId="395234ee-677e-45c2-bf71-d39fe868b890" providerId="ADAL" clId="{5856BD29-57E3-461A-8EA3-9CCC9889096A}" dt="2022-07-13T23:41:03.078" v="547" actId="21"/>
          <ac:cxnSpMkLst>
            <pc:docMk/>
            <pc:sldMk cId="3791221629" sldId="276"/>
            <ac:cxnSpMk id="4" creationId="{2EA6980B-1D96-4E9B-2E56-CFC83674CDB3}"/>
          </ac:cxnSpMkLst>
        </pc:cxnChg>
      </pc:sldChg>
      <pc:sldChg chg="addSp delSp modSp new mod">
        <pc:chgData name="Vujanovic, Lazar Nikola" userId="395234ee-677e-45c2-bf71-d39fe868b890" providerId="ADAL" clId="{5856BD29-57E3-461A-8EA3-9CCC9889096A}" dt="2022-07-14T00:19:16.534" v="554" actId="20577"/>
        <pc:sldMkLst>
          <pc:docMk/>
          <pc:sldMk cId="16116568" sldId="277"/>
        </pc:sldMkLst>
        <pc:spChg chg="add del mod">
          <ac:chgData name="Vujanovic, Lazar Nikola" userId="395234ee-677e-45c2-bf71-d39fe868b890" providerId="ADAL" clId="{5856BD29-57E3-461A-8EA3-9CCC9889096A}" dt="2022-07-12T15:41:40.176" v="160" actId="478"/>
          <ac:spMkLst>
            <pc:docMk/>
            <pc:sldMk cId="16116568" sldId="277"/>
            <ac:spMk id="2" creationId="{323E60B2-527D-8DE4-6F50-31830965B89D}"/>
          </ac:spMkLst>
        </pc:spChg>
        <pc:spChg chg="add mod">
          <ac:chgData name="Vujanovic, Lazar Nikola" userId="395234ee-677e-45c2-bf71-d39fe868b890" providerId="ADAL" clId="{5856BD29-57E3-461A-8EA3-9CCC9889096A}" dt="2022-07-14T00:19:16.534" v="554" actId="20577"/>
          <ac:spMkLst>
            <pc:docMk/>
            <pc:sldMk cId="16116568" sldId="277"/>
            <ac:spMk id="3" creationId="{D433092E-3C36-D31A-0DC3-E4DFB116964B}"/>
          </ac:spMkLst>
        </pc:spChg>
        <pc:spChg chg="mod">
          <ac:chgData name="Vujanovic, Lazar Nikola" userId="395234ee-677e-45c2-bf71-d39fe868b890" providerId="ADAL" clId="{5856BD29-57E3-461A-8EA3-9CCC9889096A}" dt="2022-07-12T15:43:10.928" v="186" actId="113"/>
          <ac:spMkLst>
            <pc:docMk/>
            <pc:sldMk cId="16116568" sldId="277"/>
            <ac:spMk id="9" creationId="{D481BA3C-C957-BBF7-7809-D69C7984DD95}"/>
          </ac:spMkLst>
        </pc:spChg>
        <pc:spChg chg="mod">
          <ac:chgData name="Vujanovic, Lazar Nikola" userId="395234ee-677e-45c2-bf71-d39fe868b890" providerId="ADAL" clId="{5856BD29-57E3-461A-8EA3-9CCC9889096A}" dt="2022-07-12T15:43:10.928" v="186" actId="113"/>
          <ac:spMkLst>
            <pc:docMk/>
            <pc:sldMk cId="16116568" sldId="277"/>
            <ac:spMk id="10" creationId="{0918E451-01E5-C640-C765-398144F190CF}"/>
          </ac:spMkLst>
        </pc:spChg>
        <pc:spChg chg="mod">
          <ac:chgData name="Vujanovic, Lazar Nikola" userId="395234ee-677e-45c2-bf71-d39fe868b890" providerId="ADAL" clId="{5856BD29-57E3-461A-8EA3-9CCC9889096A}" dt="2022-07-12T15:43:10.928" v="186" actId="113"/>
          <ac:spMkLst>
            <pc:docMk/>
            <pc:sldMk cId="16116568" sldId="277"/>
            <ac:spMk id="11" creationId="{310F711F-278A-DC3A-08C8-6BD0016F8B73}"/>
          </ac:spMkLst>
        </pc:spChg>
        <pc:spChg chg="mod">
          <ac:chgData name="Vujanovic, Lazar Nikola" userId="395234ee-677e-45c2-bf71-d39fe868b890" providerId="ADAL" clId="{5856BD29-57E3-461A-8EA3-9CCC9889096A}" dt="2022-07-12T15:43:10.928" v="186" actId="113"/>
          <ac:spMkLst>
            <pc:docMk/>
            <pc:sldMk cId="16116568" sldId="277"/>
            <ac:spMk id="12" creationId="{AAAA08DC-0433-719B-C331-3E7D038EA111}"/>
          </ac:spMkLst>
        </pc:spChg>
        <pc:grpChg chg="add mod">
          <ac:chgData name="Vujanovic, Lazar Nikola" userId="395234ee-677e-45c2-bf71-d39fe868b890" providerId="ADAL" clId="{5856BD29-57E3-461A-8EA3-9CCC9889096A}" dt="2022-07-12T15:42:09.863" v="162" actId="1076"/>
          <ac:grpSpMkLst>
            <pc:docMk/>
            <pc:sldMk cId="16116568" sldId="277"/>
            <ac:grpSpMk id="4" creationId="{43942C8B-15B2-BB35-F4D8-E96365FA32DC}"/>
          </ac:grpSpMkLst>
        </pc:grpChg>
        <pc:picChg chg="mod">
          <ac:chgData name="Vujanovic, Lazar Nikola" userId="395234ee-677e-45c2-bf71-d39fe868b890" providerId="ADAL" clId="{5856BD29-57E3-461A-8EA3-9CCC9889096A}" dt="2022-07-12T15:42:03.254" v="161"/>
          <ac:picMkLst>
            <pc:docMk/>
            <pc:sldMk cId="16116568" sldId="277"/>
            <ac:picMk id="5" creationId="{C2BB577A-4810-242C-01B7-E3C6E4387321}"/>
          </ac:picMkLst>
        </pc:picChg>
        <pc:picChg chg="mod">
          <ac:chgData name="Vujanovic, Lazar Nikola" userId="395234ee-677e-45c2-bf71-d39fe868b890" providerId="ADAL" clId="{5856BD29-57E3-461A-8EA3-9CCC9889096A}" dt="2022-07-12T15:42:03.254" v="161"/>
          <ac:picMkLst>
            <pc:docMk/>
            <pc:sldMk cId="16116568" sldId="277"/>
            <ac:picMk id="6" creationId="{DC8B2A65-053A-E19E-20B5-F213BA99F9B1}"/>
          </ac:picMkLst>
        </pc:picChg>
        <pc:picChg chg="mod">
          <ac:chgData name="Vujanovic, Lazar Nikola" userId="395234ee-677e-45c2-bf71-d39fe868b890" providerId="ADAL" clId="{5856BD29-57E3-461A-8EA3-9CCC9889096A}" dt="2022-07-12T15:42:03.254" v="161"/>
          <ac:picMkLst>
            <pc:docMk/>
            <pc:sldMk cId="16116568" sldId="277"/>
            <ac:picMk id="7" creationId="{7E1EEAA2-FAEB-4174-D65F-AFFCFB3CD500}"/>
          </ac:picMkLst>
        </pc:picChg>
        <pc:picChg chg="mod">
          <ac:chgData name="Vujanovic, Lazar Nikola" userId="395234ee-677e-45c2-bf71-d39fe868b890" providerId="ADAL" clId="{5856BD29-57E3-461A-8EA3-9CCC9889096A}" dt="2022-07-12T15:42:03.254" v="161"/>
          <ac:picMkLst>
            <pc:docMk/>
            <pc:sldMk cId="16116568" sldId="277"/>
            <ac:picMk id="8" creationId="{E95C5F9D-0014-9D49-F4C9-93934309452F}"/>
          </ac:picMkLst>
        </pc:picChg>
      </pc:sldChg>
    </pc:docChg>
  </pc:docChgLst>
  <pc:docChgLst>
    <pc:chgData name="Lazar Vujanovic" userId="395234ee-677e-45c2-bf71-d39fe868b890" providerId="ADAL" clId="{9F7EEF39-05AD-4615-9AD0-CA5E458E7428}"/>
    <pc:docChg chg="custSel addSld delSld modSld sldOrd">
      <pc:chgData name="Lazar Vujanovic" userId="395234ee-677e-45c2-bf71-d39fe868b890" providerId="ADAL" clId="{9F7EEF39-05AD-4615-9AD0-CA5E458E7428}" dt="2022-03-31T19:15:59.850" v="82" actId="2696"/>
      <pc:docMkLst>
        <pc:docMk/>
      </pc:docMkLst>
      <pc:sldChg chg="modSp mod">
        <pc:chgData name="Lazar Vujanovic" userId="395234ee-677e-45c2-bf71-d39fe868b890" providerId="ADAL" clId="{9F7EEF39-05AD-4615-9AD0-CA5E458E7428}" dt="2022-03-29T15:38:02.123" v="20" actId="12788"/>
        <pc:sldMkLst>
          <pc:docMk/>
          <pc:sldMk cId="3225534328" sldId="257"/>
        </pc:sldMkLst>
        <pc:spChg chg="mod">
          <ac:chgData name="Lazar Vujanovic" userId="395234ee-677e-45c2-bf71-d39fe868b890" providerId="ADAL" clId="{9F7EEF39-05AD-4615-9AD0-CA5E458E7428}" dt="2022-03-29T15:38:02.123" v="20" actId="12788"/>
          <ac:spMkLst>
            <pc:docMk/>
            <pc:sldMk cId="3225534328" sldId="257"/>
            <ac:spMk id="12" creationId="{703A0EA3-1B7E-415F-8527-FC6FC45EE7E2}"/>
          </ac:spMkLst>
        </pc:spChg>
      </pc:sldChg>
      <pc:sldChg chg="del">
        <pc:chgData name="Lazar Vujanovic" userId="395234ee-677e-45c2-bf71-d39fe868b890" providerId="ADAL" clId="{9F7EEF39-05AD-4615-9AD0-CA5E458E7428}" dt="2022-03-29T15:42:41.199" v="50" actId="2696"/>
        <pc:sldMkLst>
          <pc:docMk/>
          <pc:sldMk cId="2541859317" sldId="262"/>
        </pc:sldMkLst>
      </pc:sldChg>
      <pc:sldChg chg="addSp delSp modSp mod">
        <pc:chgData name="Lazar Vujanovic" userId="395234ee-677e-45c2-bf71-d39fe868b890" providerId="ADAL" clId="{9F7EEF39-05AD-4615-9AD0-CA5E458E7428}" dt="2022-03-29T15:39:08.173" v="49" actId="120"/>
        <pc:sldMkLst>
          <pc:docMk/>
          <pc:sldMk cId="1002879031" sldId="263"/>
        </pc:sldMkLst>
        <pc:spChg chg="del">
          <ac:chgData name="Lazar Vujanovic" userId="395234ee-677e-45c2-bf71-d39fe868b890" providerId="ADAL" clId="{9F7EEF39-05AD-4615-9AD0-CA5E458E7428}" dt="2022-03-29T15:37:22.278" v="0" actId="478"/>
          <ac:spMkLst>
            <pc:docMk/>
            <pc:sldMk cId="1002879031" sldId="263"/>
            <ac:spMk id="15" creationId="{61EB83E7-6239-48BC-AB03-D51106F308F1}"/>
          </ac:spMkLst>
        </pc:spChg>
        <pc:spChg chg="del">
          <ac:chgData name="Lazar Vujanovic" userId="395234ee-677e-45c2-bf71-d39fe868b890" providerId="ADAL" clId="{9F7EEF39-05AD-4615-9AD0-CA5E458E7428}" dt="2022-03-29T15:37:22.278" v="0" actId="478"/>
          <ac:spMkLst>
            <pc:docMk/>
            <pc:sldMk cId="1002879031" sldId="263"/>
            <ac:spMk id="16" creationId="{549141EF-FD9C-4F59-8A21-DC10AD8A323B}"/>
          </ac:spMkLst>
        </pc:spChg>
        <pc:spChg chg="del">
          <ac:chgData name="Lazar Vujanovic" userId="395234ee-677e-45c2-bf71-d39fe868b890" providerId="ADAL" clId="{9F7EEF39-05AD-4615-9AD0-CA5E458E7428}" dt="2022-03-29T15:37:22.278" v="0" actId="478"/>
          <ac:spMkLst>
            <pc:docMk/>
            <pc:sldMk cId="1002879031" sldId="263"/>
            <ac:spMk id="17" creationId="{163CB289-4ADE-41C1-AA26-D18946AD25AE}"/>
          </ac:spMkLst>
        </pc:spChg>
        <pc:spChg chg="mod">
          <ac:chgData name="Lazar Vujanovic" userId="395234ee-677e-45c2-bf71-d39fe868b890" providerId="ADAL" clId="{9F7EEF39-05AD-4615-9AD0-CA5E458E7428}" dt="2022-03-29T15:38:12.597" v="25" actId="1076"/>
          <ac:spMkLst>
            <pc:docMk/>
            <pc:sldMk cId="1002879031" sldId="263"/>
            <ac:spMk id="18" creationId="{8670AEA0-CF4E-47CA-86FB-4C5A10725090}"/>
          </ac:spMkLst>
        </pc:spChg>
        <pc:spChg chg="mod">
          <ac:chgData name="Lazar Vujanovic" userId="395234ee-677e-45c2-bf71-d39fe868b890" providerId="ADAL" clId="{9F7EEF39-05AD-4615-9AD0-CA5E458E7428}" dt="2022-03-29T15:39:08.173" v="49" actId="120"/>
          <ac:spMkLst>
            <pc:docMk/>
            <pc:sldMk cId="1002879031" sldId="263"/>
            <ac:spMk id="21" creationId="{8D00BEE3-B0A0-455C-AA23-7C9AB47D1645}"/>
          </ac:spMkLst>
        </pc:spChg>
        <pc:spChg chg="mod">
          <ac:chgData name="Lazar Vujanovic" userId="395234ee-677e-45c2-bf71-d39fe868b890" providerId="ADAL" clId="{9F7EEF39-05AD-4615-9AD0-CA5E458E7428}" dt="2022-03-29T15:37:27.531" v="2"/>
          <ac:spMkLst>
            <pc:docMk/>
            <pc:sldMk cId="1002879031" sldId="263"/>
            <ac:spMk id="22" creationId="{EDCBBF25-F53E-4913-BB84-59DC9FD5CDB0}"/>
          </ac:spMkLst>
        </pc:spChg>
        <pc:spChg chg="mod">
          <ac:chgData name="Lazar Vujanovic" userId="395234ee-677e-45c2-bf71-d39fe868b890" providerId="ADAL" clId="{9F7EEF39-05AD-4615-9AD0-CA5E458E7428}" dt="2022-03-29T15:37:27.531" v="2"/>
          <ac:spMkLst>
            <pc:docMk/>
            <pc:sldMk cId="1002879031" sldId="263"/>
            <ac:spMk id="23" creationId="{69BF0ED9-387A-480E-BADA-CF04AFA992F8}"/>
          </ac:spMkLst>
        </pc:spChg>
        <pc:spChg chg="mod">
          <ac:chgData name="Lazar Vujanovic" userId="395234ee-677e-45c2-bf71-d39fe868b890" providerId="ADAL" clId="{9F7EEF39-05AD-4615-9AD0-CA5E458E7428}" dt="2022-03-29T15:37:27.531" v="2"/>
          <ac:spMkLst>
            <pc:docMk/>
            <pc:sldMk cId="1002879031" sldId="263"/>
            <ac:spMk id="24" creationId="{BDA40F1B-F486-47E0-B86C-B75611AAE4B0}"/>
          </ac:spMkLst>
        </pc:spChg>
        <pc:spChg chg="mod">
          <ac:chgData name="Lazar Vujanovic" userId="395234ee-677e-45c2-bf71-d39fe868b890" providerId="ADAL" clId="{9F7EEF39-05AD-4615-9AD0-CA5E458E7428}" dt="2022-03-29T15:37:27.531" v="2"/>
          <ac:spMkLst>
            <pc:docMk/>
            <pc:sldMk cId="1002879031" sldId="263"/>
            <ac:spMk id="25" creationId="{B530E8A6-CED6-4211-A594-351D5695BD9E}"/>
          </ac:spMkLst>
        </pc:spChg>
        <pc:spChg chg="mod">
          <ac:chgData name="Lazar Vujanovic" userId="395234ee-677e-45c2-bf71-d39fe868b890" providerId="ADAL" clId="{9F7EEF39-05AD-4615-9AD0-CA5E458E7428}" dt="2022-03-29T15:37:27.531" v="2"/>
          <ac:spMkLst>
            <pc:docMk/>
            <pc:sldMk cId="1002879031" sldId="263"/>
            <ac:spMk id="26" creationId="{9AC19987-F263-48E0-AD9D-493BB251B496}"/>
          </ac:spMkLst>
        </pc:spChg>
        <pc:spChg chg="mod">
          <ac:chgData name="Lazar Vujanovic" userId="395234ee-677e-45c2-bf71-d39fe868b890" providerId="ADAL" clId="{9F7EEF39-05AD-4615-9AD0-CA5E458E7428}" dt="2022-03-29T15:37:27.531" v="2"/>
          <ac:spMkLst>
            <pc:docMk/>
            <pc:sldMk cId="1002879031" sldId="263"/>
            <ac:spMk id="27" creationId="{626A3A20-4470-49DB-BDB7-EDEB7FB376EA}"/>
          </ac:spMkLst>
        </pc:spChg>
        <pc:spChg chg="mod">
          <ac:chgData name="Lazar Vujanovic" userId="395234ee-677e-45c2-bf71-d39fe868b890" providerId="ADAL" clId="{9F7EEF39-05AD-4615-9AD0-CA5E458E7428}" dt="2022-03-29T15:37:27.531" v="2"/>
          <ac:spMkLst>
            <pc:docMk/>
            <pc:sldMk cId="1002879031" sldId="263"/>
            <ac:spMk id="28" creationId="{EB0B5F2C-F011-471E-9E7C-91EFA6748DC3}"/>
          </ac:spMkLst>
        </pc:spChg>
        <pc:spChg chg="mod">
          <ac:chgData name="Lazar Vujanovic" userId="395234ee-677e-45c2-bf71-d39fe868b890" providerId="ADAL" clId="{9F7EEF39-05AD-4615-9AD0-CA5E458E7428}" dt="2022-03-29T15:37:27.531" v="2"/>
          <ac:spMkLst>
            <pc:docMk/>
            <pc:sldMk cId="1002879031" sldId="263"/>
            <ac:spMk id="33" creationId="{41107848-DC30-4B68-820A-A14D63C3D171}"/>
          </ac:spMkLst>
        </pc:spChg>
        <pc:grpChg chg="del">
          <ac:chgData name="Lazar Vujanovic" userId="395234ee-677e-45c2-bf71-d39fe868b890" providerId="ADAL" clId="{9F7EEF39-05AD-4615-9AD0-CA5E458E7428}" dt="2022-03-29T15:37:22.278" v="0" actId="478"/>
          <ac:grpSpMkLst>
            <pc:docMk/>
            <pc:sldMk cId="1002879031" sldId="263"/>
            <ac:grpSpMk id="5" creationId="{03996424-8E69-4F75-BE5D-C48A95B33856}"/>
          </ac:grpSpMkLst>
        </pc:grpChg>
        <pc:grpChg chg="del">
          <ac:chgData name="Lazar Vujanovic" userId="395234ee-677e-45c2-bf71-d39fe868b890" providerId="ADAL" clId="{9F7EEF39-05AD-4615-9AD0-CA5E458E7428}" dt="2022-03-29T15:37:22.278" v="0" actId="478"/>
          <ac:grpSpMkLst>
            <pc:docMk/>
            <pc:sldMk cId="1002879031" sldId="263"/>
            <ac:grpSpMk id="14" creationId="{EA1F3CEB-E7BE-4939-A256-9F17A2E20BE4}"/>
          </ac:grpSpMkLst>
        </pc:grpChg>
        <pc:grpChg chg="add mod">
          <ac:chgData name="Lazar Vujanovic" userId="395234ee-677e-45c2-bf71-d39fe868b890" providerId="ADAL" clId="{9F7EEF39-05AD-4615-9AD0-CA5E458E7428}" dt="2022-03-29T15:38:59.317" v="48" actId="14100"/>
          <ac:grpSpMkLst>
            <pc:docMk/>
            <pc:sldMk cId="1002879031" sldId="263"/>
            <ac:grpSpMk id="19" creationId="{45FBD404-CA4B-455C-8B39-C2754CC725B0}"/>
          </ac:grpSpMkLst>
        </pc:grpChg>
        <pc:grpChg chg="mod">
          <ac:chgData name="Lazar Vujanovic" userId="395234ee-677e-45c2-bf71-d39fe868b890" providerId="ADAL" clId="{9F7EEF39-05AD-4615-9AD0-CA5E458E7428}" dt="2022-03-29T15:37:27.531" v="2"/>
          <ac:grpSpMkLst>
            <pc:docMk/>
            <pc:sldMk cId="1002879031" sldId="263"/>
            <ac:grpSpMk id="20" creationId="{0BCD3E6F-0468-483C-9FD8-16E79E551800}"/>
          </ac:grpSpMkLst>
        </pc:grpChg>
        <pc:grpChg chg="add mod">
          <ac:chgData name="Lazar Vujanovic" userId="395234ee-677e-45c2-bf71-d39fe868b890" providerId="ADAL" clId="{9F7EEF39-05AD-4615-9AD0-CA5E458E7428}" dt="2022-03-29T15:37:27.531" v="2"/>
          <ac:grpSpMkLst>
            <pc:docMk/>
            <pc:sldMk cId="1002879031" sldId="263"/>
            <ac:grpSpMk id="29" creationId="{B5E086B7-E787-4294-85CB-9305A3636BE5}"/>
          </ac:grpSpMkLst>
        </pc:grpChg>
        <pc:picChg chg="mod">
          <ac:chgData name="Lazar Vujanovic" userId="395234ee-677e-45c2-bf71-d39fe868b890" providerId="ADAL" clId="{9F7EEF39-05AD-4615-9AD0-CA5E458E7428}" dt="2022-03-29T15:37:27.531" v="2"/>
          <ac:picMkLst>
            <pc:docMk/>
            <pc:sldMk cId="1002879031" sldId="263"/>
            <ac:picMk id="30" creationId="{420F9E0A-485D-429F-BB60-7388D0B739C4}"/>
          </ac:picMkLst>
        </pc:picChg>
        <pc:picChg chg="mod">
          <ac:chgData name="Lazar Vujanovic" userId="395234ee-677e-45c2-bf71-d39fe868b890" providerId="ADAL" clId="{9F7EEF39-05AD-4615-9AD0-CA5E458E7428}" dt="2022-03-29T15:37:27.531" v="2"/>
          <ac:picMkLst>
            <pc:docMk/>
            <pc:sldMk cId="1002879031" sldId="263"/>
            <ac:picMk id="31" creationId="{5868E5ED-0987-4D8E-A350-6491B21F5B28}"/>
          </ac:picMkLst>
        </pc:picChg>
        <pc:picChg chg="mod">
          <ac:chgData name="Lazar Vujanovic" userId="395234ee-677e-45c2-bf71-d39fe868b890" providerId="ADAL" clId="{9F7EEF39-05AD-4615-9AD0-CA5E458E7428}" dt="2022-03-29T15:37:27.531" v="2"/>
          <ac:picMkLst>
            <pc:docMk/>
            <pc:sldMk cId="1002879031" sldId="263"/>
            <ac:picMk id="32" creationId="{E79CC2B4-FDDF-4690-80C1-C19EEEF8223D}"/>
          </ac:picMkLst>
        </pc:picChg>
      </pc:sldChg>
      <pc:sldChg chg="del">
        <pc:chgData name="Lazar Vujanovic" userId="395234ee-677e-45c2-bf71-d39fe868b890" providerId="ADAL" clId="{9F7EEF39-05AD-4615-9AD0-CA5E458E7428}" dt="2022-03-29T16:21:04.965" v="52" actId="2696"/>
        <pc:sldMkLst>
          <pc:docMk/>
          <pc:sldMk cId="3561562930" sldId="265"/>
        </pc:sldMkLst>
      </pc:sldChg>
      <pc:sldChg chg="ord">
        <pc:chgData name="Lazar Vujanovic" userId="395234ee-677e-45c2-bf71-d39fe868b890" providerId="ADAL" clId="{9F7EEF39-05AD-4615-9AD0-CA5E458E7428}" dt="2022-03-29T16:49:13.797" v="59"/>
        <pc:sldMkLst>
          <pc:docMk/>
          <pc:sldMk cId="2634600653" sldId="270"/>
        </pc:sldMkLst>
      </pc:sldChg>
      <pc:sldChg chg="addSp delSp modSp mod">
        <pc:chgData name="Lazar Vujanovic" userId="395234ee-677e-45c2-bf71-d39fe868b890" providerId="ADAL" clId="{9F7EEF39-05AD-4615-9AD0-CA5E458E7428}" dt="2022-03-31T19:15:52.902" v="81"/>
        <pc:sldMkLst>
          <pc:docMk/>
          <pc:sldMk cId="2173377607" sldId="272"/>
        </pc:sldMkLst>
        <pc:spChg chg="mod">
          <ac:chgData name="Lazar Vujanovic" userId="395234ee-677e-45c2-bf71-d39fe868b890" providerId="ADAL" clId="{9F7EEF39-05AD-4615-9AD0-CA5E458E7428}" dt="2022-03-29T16:21:24.089" v="55" actId="20577"/>
          <ac:spMkLst>
            <pc:docMk/>
            <pc:sldMk cId="2173377607" sldId="272"/>
            <ac:spMk id="2" creationId="{0E177EA3-1C8F-4122-B14C-7FFF7B5757DA}"/>
          </ac:spMkLst>
        </pc:spChg>
        <pc:picChg chg="add mod">
          <ac:chgData name="Lazar Vujanovic" userId="395234ee-677e-45c2-bf71-d39fe868b890" providerId="ADAL" clId="{9F7EEF39-05AD-4615-9AD0-CA5E458E7428}" dt="2022-03-31T19:15:52.902" v="81"/>
          <ac:picMkLst>
            <pc:docMk/>
            <pc:sldMk cId="2173377607" sldId="272"/>
            <ac:picMk id="19" creationId="{68852E6E-46E3-42CD-A6AB-ADC046764EBF}"/>
          </ac:picMkLst>
        </pc:picChg>
        <pc:picChg chg="add mod">
          <ac:chgData name="Lazar Vujanovic" userId="395234ee-677e-45c2-bf71-d39fe868b890" providerId="ADAL" clId="{9F7EEF39-05AD-4615-9AD0-CA5E458E7428}" dt="2022-03-31T19:15:52.902" v="81"/>
          <ac:picMkLst>
            <pc:docMk/>
            <pc:sldMk cId="2173377607" sldId="272"/>
            <ac:picMk id="20" creationId="{3964B8FC-7957-474D-BF19-9E03A821ABFC}"/>
          </ac:picMkLst>
        </pc:picChg>
        <pc:picChg chg="del">
          <ac:chgData name="Lazar Vujanovic" userId="395234ee-677e-45c2-bf71-d39fe868b890" providerId="ADAL" clId="{9F7EEF39-05AD-4615-9AD0-CA5E458E7428}" dt="2022-03-31T19:15:51.675" v="80" actId="478"/>
          <ac:picMkLst>
            <pc:docMk/>
            <pc:sldMk cId="2173377607" sldId="272"/>
            <ac:picMk id="21" creationId="{C028BBA4-57E9-43CB-94E5-839EB3BC1A53}"/>
          </ac:picMkLst>
        </pc:picChg>
        <pc:picChg chg="del">
          <ac:chgData name="Lazar Vujanovic" userId="395234ee-677e-45c2-bf71-d39fe868b890" providerId="ADAL" clId="{9F7EEF39-05AD-4615-9AD0-CA5E458E7428}" dt="2022-03-31T19:15:51.675" v="80" actId="478"/>
          <ac:picMkLst>
            <pc:docMk/>
            <pc:sldMk cId="2173377607" sldId="272"/>
            <ac:picMk id="22" creationId="{9EB45C0F-1608-47D7-A6D0-27002C983FE3}"/>
          </ac:picMkLst>
        </pc:picChg>
      </pc:sldChg>
      <pc:sldChg chg="modSp mod">
        <pc:chgData name="Lazar Vujanovic" userId="395234ee-677e-45c2-bf71-d39fe868b890" providerId="ADAL" clId="{9F7EEF39-05AD-4615-9AD0-CA5E458E7428}" dt="2022-03-29T18:00:02.488" v="62" actId="14100"/>
        <pc:sldMkLst>
          <pc:docMk/>
          <pc:sldMk cId="3791221629" sldId="276"/>
        </pc:sldMkLst>
        <pc:spChg chg="mod">
          <ac:chgData name="Lazar Vujanovic" userId="395234ee-677e-45c2-bf71-d39fe868b890" providerId="ADAL" clId="{9F7EEF39-05AD-4615-9AD0-CA5E458E7428}" dt="2022-03-29T18:00:02.488" v="62" actId="14100"/>
          <ac:spMkLst>
            <pc:docMk/>
            <pc:sldMk cId="3791221629" sldId="276"/>
            <ac:spMk id="7" creationId="{61950A7A-B517-4EED-AA5A-8CEF3C8364C6}"/>
          </ac:spMkLst>
        </pc:spChg>
      </pc:sldChg>
      <pc:sldChg chg="addSp delSp modSp new del mod">
        <pc:chgData name="Lazar Vujanovic" userId="395234ee-677e-45c2-bf71-d39fe868b890" providerId="ADAL" clId="{9F7EEF39-05AD-4615-9AD0-CA5E458E7428}" dt="2022-03-31T19:15:59.850" v="82" actId="2696"/>
        <pc:sldMkLst>
          <pc:docMk/>
          <pc:sldMk cId="1986579998" sldId="277"/>
        </pc:sldMkLst>
        <pc:picChg chg="add del mod">
          <ac:chgData name="Lazar Vujanovic" userId="395234ee-677e-45c2-bf71-d39fe868b890" providerId="ADAL" clId="{9F7EEF39-05AD-4615-9AD0-CA5E458E7428}" dt="2022-03-31T19:15:48.343" v="79" actId="21"/>
          <ac:picMkLst>
            <pc:docMk/>
            <pc:sldMk cId="1986579998" sldId="277"/>
            <ac:picMk id="2" creationId="{4B8513F3-4E7D-4175-971B-EE51E2134752}"/>
          </ac:picMkLst>
        </pc:picChg>
        <pc:picChg chg="add del mod">
          <ac:chgData name="Lazar Vujanovic" userId="395234ee-677e-45c2-bf71-d39fe868b890" providerId="ADAL" clId="{9F7EEF39-05AD-4615-9AD0-CA5E458E7428}" dt="2022-03-31T18:39:40.037" v="69" actId="478"/>
          <ac:picMkLst>
            <pc:docMk/>
            <pc:sldMk cId="1986579998" sldId="277"/>
            <ac:picMk id="3" creationId="{A3EC60D7-C381-430B-844E-597F85E9B744}"/>
          </ac:picMkLst>
        </pc:picChg>
        <pc:picChg chg="add del mod">
          <ac:chgData name="Lazar Vujanovic" userId="395234ee-677e-45c2-bf71-d39fe868b890" providerId="ADAL" clId="{9F7EEF39-05AD-4615-9AD0-CA5E458E7428}" dt="2022-03-31T18:44:52.722" v="72" actId="478"/>
          <ac:picMkLst>
            <pc:docMk/>
            <pc:sldMk cId="1986579998" sldId="277"/>
            <ac:picMk id="4" creationId="{CE048299-3926-460F-BD7B-866EE8886267}"/>
          </ac:picMkLst>
        </pc:picChg>
        <pc:picChg chg="add del mod">
          <ac:chgData name="Lazar Vujanovic" userId="395234ee-677e-45c2-bf71-d39fe868b890" providerId="ADAL" clId="{9F7EEF39-05AD-4615-9AD0-CA5E458E7428}" dt="2022-03-31T19:15:48.343" v="79" actId="21"/>
          <ac:picMkLst>
            <pc:docMk/>
            <pc:sldMk cId="1986579998" sldId="277"/>
            <ac:picMk id="5" creationId="{5E892881-1F8B-41AF-9D9F-3A46E0246A2E}"/>
          </ac:picMkLst>
        </pc:picChg>
      </pc:sldChg>
      <pc:sldChg chg="modSp del mod">
        <pc:chgData name="Lazar Vujanovic" userId="395234ee-677e-45c2-bf71-d39fe868b890" providerId="ADAL" clId="{9F7EEF39-05AD-4615-9AD0-CA5E458E7428}" dt="2022-03-29T16:21:11.832" v="53" actId="2696"/>
        <pc:sldMkLst>
          <pc:docMk/>
          <pc:sldMk cId="3772167434" sldId="277"/>
        </pc:sldMkLst>
        <pc:picChg chg="mod">
          <ac:chgData name="Lazar Vujanovic" userId="395234ee-677e-45c2-bf71-d39fe868b890" providerId="ADAL" clId="{9F7EEF39-05AD-4615-9AD0-CA5E458E7428}" dt="2022-03-29T15:46:27.334" v="51" actId="1076"/>
          <ac:picMkLst>
            <pc:docMk/>
            <pc:sldMk cId="3772167434" sldId="277"/>
            <ac:picMk id="3" creationId="{73E8B5E7-DD21-4A0F-A147-573A6AD2ABA9}"/>
          </ac:picMkLst>
        </pc:picChg>
      </pc:sldChg>
      <pc:sldChg chg="delSp del mod">
        <pc:chgData name="Lazar Vujanovic" userId="395234ee-677e-45c2-bf71-d39fe868b890" providerId="ADAL" clId="{9F7EEF39-05AD-4615-9AD0-CA5E458E7428}" dt="2022-03-29T15:37:30.864" v="3" actId="2696"/>
        <pc:sldMkLst>
          <pc:docMk/>
          <pc:sldMk cId="3107236883" sldId="278"/>
        </pc:sldMkLst>
        <pc:grpChg chg="del">
          <ac:chgData name="Lazar Vujanovic" userId="395234ee-677e-45c2-bf71-d39fe868b890" providerId="ADAL" clId="{9F7EEF39-05AD-4615-9AD0-CA5E458E7428}" dt="2022-03-29T15:37:26.125" v="1" actId="21"/>
          <ac:grpSpMkLst>
            <pc:docMk/>
            <pc:sldMk cId="3107236883" sldId="278"/>
            <ac:grpSpMk id="3" creationId="{F68B7E4D-37F3-4B01-A0E5-5A7ECBF27049}"/>
          </ac:grpSpMkLst>
        </pc:grpChg>
        <pc:grpChg chg="del">
          <ac:chgData name="Lazar Vujanovic" userId="395234ee-677e-45c2-bf71-d39fe868b890" providerId="ADAL" clId="{9F7EEF39-05AD-4615-9AD0-CA5E458E7428}" dt="2022-03-29T15:37:26.125" v="1" actId="21"/>
          <ac:grpSpMkLst>
            <pc:docMk/>
            <pc:sldMk cId="3107236883" sldId="278"/>
            <ac:grpSpMk id="5" creationId="{BEB405E8-3F4F-471F-905A-D711F57DCD83}"/>
          </ac:grpSpMkLst>
        </pc:grpChg>
      </pc:sldChg>
    </pc:docChg>
  </pc:docChgLst>
  <pc:docChgLst>
    <pc:chgData name="Vujanovic, Lazar Nikola" userId="395234ee-677e-45c2-bf71-d39fe868b890" providerId="ADAL" clId="{2D556389-9772-485A-A270-672B54D2387D}"/>
    <pc:docChg chg="undo custSel modSld">
      <pc:chgData name="Vujanovic, Lazar Nikola" userId="395234ee-677e-45c2-bf71-d39fe868b890" providerId="ADAL" clId="{2D556389-9772-485A-A270-672B54D2387D}" dt="2022-04-02T05:48:47.163" v="236" actId="1076"/>
      <pc:docMkLst>
        <pc:docMk/>
      </pc:docMkLst>
      <pc:sldChg chg="addSp delSp modSp mod">
        <pc:chgData name="Vujanovic, Lazar Nikola" userId="395234ee-677e-45c2-bf71-d39fe868b890" providerId="ADAL" clId="{2D556389-9772-485A-A270-672B54D2387D}" dt="2022-04-02T03:47:48.337" v="103" actId="164"/>
        <pc:sldMkLst>
          <pc:docMk/>
          <pc:sldMk cId="1002879031" sldId="263"/>
        </pc:sldMkLst>
        <pc:spChg chg="add mod ord topLvl">
          <ac:chgData name="Vujanovic, Lazar Nikola" userId="395234ee-677e-45c2-bf71-d39fe868b890" providerId="ADAL" clId="{2D556389-9772-485A-A270-672B54D2387D}" dt="2022-04-02T03:47:48.337" v="103" actId="164"/>
          <ac:spMkLst>
            <pc:docMk/>
            <pc:sldMk cId="1002879031" sldId="263"/>
            <ac:spMk id="3" creationId="{D4130D8E-9304-477F-A93C-4697396F533E}"/>
          </ac:spMkLst>
        </pc:spChg>
        <pc:spChg chg="mod">
          <ac:chgData name="Vujanovic, Lazar Nikola" userId="395234ee-677e-45c2-bf71-d39fe868b890" providerId="ADAL" clId="{2D556389-9772-485A-A270-672B54D2387D}" dt="2022-04-02T03:37:14.184" v="95" actId="6549"/>
          <ac:spMkLst>
            <pc:docMk/>
            <pc:sldMk cId="1002879031" sldId="263"/>
            <ac:spMk id="18" creationId="{8670AEA0-CF4E-47CA-86FB-4C5A10725090}"/>
          </ac:spMkLst>
        </pc:spChg>
        <pc:spChg chg="mod topLvl">
          <ac:chgData name="Vujanovic, Lazar Nikola" userId="395234ee-677e-45c2-bf71-d39fe868b890" providerId="ADAL" clId="{2D556389-9772-485A-A270-672B54D2387D}" dt="2022-04-02T03:47:42.769" v="102" actId="338"/>
          <ac:spMkLst>
            <pc:docMk/>
            <pc:sldMk cId="1002879031" sldId="263"/>
            <ac:spMk id="21" creationId="{8D00BEE3-B0A0-455C-AA23-7C9AB47D1645}"/>
          </ac:spMkLst>
        </pc:spChg>
        <pc:spChg chg="mod">
          <ac:chgData name="Vujanovic, Lazar Nikola" userId="395234ee-677e-45c2-bf71-d39fe868b890" providerId="ADAL" clId="{2D556389-9772-485A-A270-672B54D2387D}" dt="2022-04-02T03:47:31.211" v="99" actId="165"/>
          <ac:spMkLst>
            <pc:docMk/>
            <pc:sldMk cId="1002879031" sldId="263"/>
            <ac:spMk id="22" creationId="{EDCBBF25-F53E-4913-BB84-59DC9FD5CDB0}"/>
          </ac:spMkLst>
        </pc:spChg>
        <pc:spChg chg="mod">
          <ac:chgData name="Vujanovic, Lazar Nikola" userId="395234ee-677e-45c2-bf71-d39fe868b890" providerId="ADAL" clId="{2D556389-9772-485A-A270-672B54D2387D}" dt="2022-04-02T03:47:31.211" v="99" actId="165"/>
          <ac:spMkLst>
            <pc:docMk/>
            <pc:sldMk cId="1002879031" sldId="263"/>
            <ac:spMk id="23" creationId="{69BF0ED9-387A-480E-BADA-CF04AFA992F8}"/>
          </ac:spMkLst>
        </pc:spChg>
        <pc:spChg chg="mod">
          <ac:chgData name="Vujanovic, Lazar Nikola" userId="395234ee-677e-45c2-bf71-d39fe868b890" providerId="ADAL" clId="{2D556389-9772-485A-A270-672B54D2387D}" dt="2022-04-02T03:47:31.211" v="99" actId="165"/>
          <ac:spMkLst>
            <pc:docMk/>
            <pc:sldMk cId="1002879031" sldId="263"/>
            <ac:spMk id="24" creationId="{BDA40F1B-F486-47E0-B86C-B75611AAE4B0}"/>
          </ac:spMkLst>
        </pc:spChg>
        <pc:spChg chg="mod">
          <ac:chgData name="Vujanovic, Lazar Nikola" userId="395234ee-677e-45c2-bf71-d39fe868b890" providerId="ADAL" clId="{2D556389-9772-485A-A270-672B54D2387D}" dt="2022-04-02T03:47:31.211" v="99" actId="165"/>
          <ac:spMkLst>
            <pc:docMk/>
            <pc:sldMk cId="1002879031" sldId="263"/>
            <ac:spMk id="25" creationId="{B530E8A6-CED6-4211-A594-351D5695BD9E}"/>
          </ac:spMkLst>
        </pc:spChg>
        <pc:spChg chg="mod">
          <ac:chgData name="Vujanovic, Lazar Nikola" userId="395234ee-677e-45c2-bf71-d39fe868b890" providerId="ADAL" clId="{2D556389-9772-485A-A270-672B54D2387D}" dt="2022-04-02T03:47:31.211" v="99" actId="165"/>
          <ac:spMkLst>
            <pc:docMk/>
            <pc:sldMk cId="1002879031" sldId="263"/>
            <ac:spMk id="26" creationId="{9AC19987-F263-48E0-AD9D-493BB251B496}"/>
          </ac:spMkLst>
        </pc:spChg>
        <pc:spChg chg="mod">
          <ac:chgData name="Vujanovic, Lazar Nikola" userId="395234ee-677e-45c2-bf71-d39fe868b890" providerId="ADAL" clId="{2D556389-9772-485A-A270-672B54D2387D}" dt="2022-04-02T03:47:31.211" v="99" actId="165"/>
          <ac:spMkLst>
            <pc:docMk/>
            <pc:sldMk cId="1002879031" sldId="263"/>
            <ac:spMk id="27" creationId="{626A3A20-4470-49DB-BDB7-EDEB7FB376EA}"/>
          </ac:spMkLst>
        </pc:spChg>
        <pc:spChg chg="mod">
          <ac:chgData name="Vujanovic, Lazar Nikola" userId="395234ee-677e-45c2-bf71-d39fe868b890" providerId="ADAL" clId="{2D556389-9772-485A-A270-672B54D2387D}" dt="2022-04-02T03:47:31.211" v="99" actId="165"/>
          <ac:spMkLst>
            <pc:docMk/>
            <pc:sldMk cId="1002879031" sldId="263"/>
            <ac:spMk id="28" creationId="{EB0B5F2C-F011-471E-9E7C-91EFA6748DC3}"/>
          </ac:spMkLst>
        </pc:spChg>
        <pc:spChg chg="mod topLvl">
          <ac:chgData name="Vujanovic, Lazar Nikola" userId="395234ee-677e-45c2-bf71-d39fe868b890" providerId="ADAL" clId="{2D556389-9772-485A-A270-672B54D2387D}" dt="2022-04-02T03:34:04.312" v="6" actId="164"/>
          <ac:spMkLst>
            <pc:docMk/>
            <pc:sldMk cId="1002879031" sldId="263"/>
            <ac:spMk id="33" creationId="{41107848-DC30-4B68-820A-A14D63C3D171}"/>
          </ac:spMkLst>
        </pc:spChg>
        <pc:grpChg chg="add mod">
          <ac:chgData name="Vujanovic, Lazar Nikola" userId="395234ee-677e-45c2-bf71-d39fe868b890" providerId="ADAL" clId="{2D556389-9772-485A-A270-672B54D2387D}" dt="2022-04-02T03:34:57.227" v="37" actId="1076"/>
          <ac:grpSpMkLst>
            <pc:docMk/>
            <pc:sldMk cId="1002879031" sldId="263"/>
            <ac:grpSpMk id="2" creationId="{55CF9BA6-6511-483B-B157-8EE52D964BE2}"/>
          </ac:grpSpMkLst>
        </pc:grpChg>
        <pc:grpChg chg="add del mod">
          <ac:chgData name="Vujanovic, Lazar Nikola" userId="395234ee-677e-45c2-bf71-d39fe868b890" providerId="ADAL" clId="{2D556389-9772-485A-A270-672B54D2387D}" dt="2022-04-02T03:47:15.366" v="96" actId="165"/>
          <ac:grpSpMkLst>
            <pc:docMk/>
            <pc:sldMk cId="1002879031" sldId="263"/>
            <ac:grpSpMk id="4" creationId="{F08EF09E-EFD7-461B-8C28-0BA7150B799F}"/>
          </ac:grpSpMkLst>
        </pc:grpChg>
        <pc:grpChg chg="add mod">
          <ac:chgData name="Vujanovic, Lazar Nikola" userId="395234ee-677e-45c2-bf71-d39fe868b890" providerId="ADAL" clId="{2D556389-9772-485A-A270-672B54D2387D}" dt="2022-04-02T03:47:48.337" v="103" actId="164"/>
          <ac:grpSpMkLst>
            <pc:docMk/>
            <pc:sldMk cId="1002879031" sldId="263"/>
            <ac:grpSpMk id="5" creationId="{ED99E7E2-ECB6-48E7-9B86-3D782C65BAF6}"/>
          </ac:grpSpMkLst>
        </pc:grpChg>
        <pc:grpChg chg="add mod">
          <ac:chgData name="Vujanovic, Lazar Nikola" userId="395234ee-677e-45c2-bf71-d39fe868b890" providerId="ADAL" clId="{2D556389-9772-485A-A270-672B54D2387D}" dt="2022-04-02T03:47:48.337" v="103" actId="164"/>
          <ac:grpSpMkLst>
            <pc:docMk/>
            <pc:sldMk cId="1002879031" sldId="263"/>
            <ac:grpSpMk id="6" creationId="{C24AC17D-067A-42A5-8206-16D415208630}"/>
          </ac:grpSpMkLst>
        </pc:grpChg>
        <pc:grpChg chg="del mod topLvl">
          <ac:chgData name="Vujanovic, Lazar Nikola" userId="395234ee-677e-45c2-bf71-d39fe868b890" providerId="ADAL" clId="{2D556389-9772-485A-A270-672B54D2387D}" dt="2022-04-02T03:47:31.211" v="99" actId="165"/>
          <ac:grpSpMkLst>
            <pc:docMk/>
            <pc:sldMk cId="1002879031" sldId="263"/>
            <ac:grpSpMk id="19" creationId="{45FBD404-CA4B-455C-8B39-C2754CC725B0}"/>
          </ac:grpSpMkLst>
        </pc:grpChg>
        <pc:grpChg chg="mod topLvl">
          <ac:chgData name="Vujanovic, Lazar Nikola" userId="395234ee-677e-45c2-bf71-d39fe868b890" providerId="ADAL" clId="{2D556389-9772-485A-A270-672B54D2387D}" dt="2022-04-02T03:47:42.769" v="102" actId="338"/>
          <ac:grpSpMkLst>
            <pc:docMk/>
            <pc:sldMk cId="1002879031" sldId="263"/>
            <ac:grpSpMk id="20" creationId="{0BCD3E6F-0468-483C-9FD8-16E79E551800}"/>
          </ac:grpSpMkLst>
        </pc:grpChg>
        <pc:grpChg chg="del">
          <ac:chgData name="Vujanovic, Lazar Nikola" userId="395234ee-677e-45c2-bf71-d39fe868b890" providerId="ADAL" clId="{2D556389-9772-485A-A270-672B54D2387D}" dt="2022-04-02T03:33:59.924" v="5" actId="165"/>
          <ac:grpSpMkLst>
            <pc:docMk/>
            <pc:sldMk cId="1002879031" sldId="263"/>
            <ac:grpSpMk id="29" creationId="{B5E086B7-E787-4294-85CB-9305A3636BE5}"/>
          </ac:grpSpMkLst>
        </pc:grpChg>
        <pc:picChg chg="mod topLvl">
          <ac:chgData name="Vujanovic, Lazar Nikola" userId="395234ee-677e-45c2-bf71-d39fe868b890" providerId="ADAL" clId="{2D556389-9772-485A-A270-672B54D2387D}" dt="2022-04-02T03:34:47.943" v="36" actId="1076"/>
          <ac:picMkLst>
            <pc:docMk/>
            <pc:sldMk cId="1002879031" sldId="263"/>
            <ac:picMk id="30" creationId="{420F9E0A-485D-429F-BB60-7388D0B739C4}"/>
          </ac:picMkLst>
        </pc:picChg>
        <pc:picChg chg="mod topLvl">
          <ac:chgData name="Vujanovic, Lazar Nikola" userId="395234ee-677e-45c2-bf71-d39fe868b890" providerId="ADAL" clId="{2D556389-9772-485A-A270-672B54D2387D}" dt="2022-04-02T03:34:22.746" v="32" actId="1076"/>
          <ac:picMkLst>
            <pc:docMk/>
            <pc:sldMk cId="1002879031" sldId="263"/>
            <ac:picMk id="31" creationId="{5868E5ED-0987-4D8E-A350-6491B21F5B28}"/>
          </ac:picMkLst>
        </pc:picChg>
        <pc:picChg chg="mod topLvl">
          <ac:chgData name="Vujanovic, Lazar Nikola" userId="395234ee-677e-45c2-bf71-d39fe868b890" providerId="ADAL" clId="{2D556389-9772-485A-A270-672B54D2387D}" dt="2022-04-02T03:34:04.312" v="6" actId="164"/>
          <ac:picMkLst>
            <pc:docMk/>
            <pc:sldMk cId="1002879031" sldId="263"/>
            <ac:picMk id="32" creationId="{E79CC2B4-FDDF-4690-80C1-C19EEEF8223D}"/>
          </ac:picMkLst>
        </pc:picChg>
      </pc:sldChg>
      <pc:sldChg chg="addSp modSp mod">
        <pc:chgData name="Vujanovic, Lazar Nikola" userId="395234ee-677e-45c2-bf71-d39fe868b890" providerId="ADAL" clId="{2D556389-9772-485A-A270-672B54D2387D}" dt="2022-04-02T05:48:47.163" v="236" actId="1076"/>
        <pc:sldMkLst>
          <pc:docMk/>
          <pc:sldMk cId="2173377607" sldId="272"/>
        </pc:sldMkLst>
        <pc:spChg chg="add mod">
          <ac:chgData name="Vujanovic, Lazar Nikola" userId="395234ee-677e-45c2-bf71-d39fe868b890" providerId="ADAL" clId="{2D556389-9772-485A-A270-672B54D2387D}" dt="2022-04-02T05:48:40.425" v="235" actId="6549"/>
          <ac:spMkLst>
            <pc:docMk/>
            <pc:sldMk cId="2173377607" sldId="272"/>
            <ac:spMk id="21" creationId="{BBC918E2-A55F-401B-9079-4E05737121F4}"/>
          </ac:spMkLst>
        </pc:spChg>
        <pc:picChg chg="mod">
          <ac:chgData name="Vujanovic, Lazar Nikola" userId="395234ee-677e-45c2-bf71-d39fe868b890" providerId="ADAL" clId="{2D556389-9772-485A-A270-672B54D2387D}" dt="2022-04-02T05:48:47.163" v="236" actId="1076"/>
          <ac:picMkLst>
            <pc:docMk/>
            <pc:sldMk cId="2173377607" sldId="272"/>
            <ac:picMk id="20" creationId="{3964B8FC-7957-474D-BF19-9E03A821ABFC}"/>
          </ac:picMkLst>
        </pc:picChg>
      </pc:sldChg>
      <pc:sldChg chg="addSp delSp modSp mod">
        <pc:chgData name="Vujanovic, Lazar Nikola" userId="395234ee-677e-45c2-bf71-d39fe868b890" providerId="ADAL" clId="{2D556389-9772-485A-A270-672B54D2387D}" dt="2022-04-02T03:32:02.224" v="4" actId="478"/>
        <pc:sldMkLst>
          <pc:docMk/>
          <pc:sldMk cId="3791221629" sldId="276"/>
        </pc:sldMkLst>
        <pc:spChg chg="mod">
          <ac:chgData name="Vujanovic, Lazar Nikola" userId="395234ee-677e-45c2-bf71-d39fe868b890" providerId="ADAL" clId="{2D556389-9772-485A-A270-672B54D2387D}" dt="2022-04-02T03:28:07.530" v="3" actId="164"/>
          <ac:spMkLst>
            <pc:docMk/>
            <pc:sldMk cId="3791221629" sldId="276"/>
            <ac:spMk id="6" creationId="{8169A85E-FAA9-4D7D-888A-87444D776F51}"/>
          </ac:spMkLst>
        </pc:spChg>
        <pc:spChg chg="del">
          <ac:chgData name="Vujanovic, Lazar Nikola" userId="395234ee-677e-45c2-bf71-d39fe868b890" providerId="ADAL" clId="{2D556389-9772-485A-A270-672B54D2387D}" dt="2022-04-02T03:32:02.224" v="4" actId="478"/>
          <ac:spMkLst>
            <pc:docMk/>
            <pc:sldMk cId="3791221629" sldId="276"/>
            <ac:spMk id="7" creationId="{61950A7A-B517-4EED-AA5A-8CEF3C8364C6}"/>
          </ac:spMkLst>
        </pc:spChg>
        <pc:spChg chg="mod">
          <ac:chgData name="Vujanovic, Lazar Nikola" userId="395234ee-677e-45c2-bf71-d39fe868b890" providerId="ADAL" clId="{2D556389-9772-485A-A270-672B54D2387D}" dt="2022-04-02T03:28:07.530" v="3" actId="164"/>
          <ac:spMkLst>
            <pc:docMk/>
            <pc:sldMk cId="3791221629" sldId="276"/>
            <ac:spMk id="8" creationId="{4C844E56-A648-43E9-AE9B-B23BB1012533}"/>
          </ac:spMkLst>
        </pc:spChg>
        <pc:grpChg chg="add mod">
          <ac:chgData name="Vujanovic, Lazar Nikola" userId="395234ee-677e-45c2-bf71-d39fe868b890" providerId="ADAL" clId="{2D556389-9772-485A-A270-672B54D2387D}" dt="2022-04-02T03:28:07.530" v="3" actId="164"/>
          <ac:grpSpMkLst>
            <pc:docMk/>
            <pc:sldMk cId="3791221629" sldId="276"/>
            <ac:grpSpMk id="2" creationId="{CFEDC3F7-7B10-4133-A1E1-69CD9F8587A8}"/>
          </ac:grpSpMkLst>
        </pc:grpChg>
        <pc:graphicFrameChg chg="mod">
          <ac:chgData name="Vujanovic, Lazar Nikola" userId="395234ee-677e-45c2-bf71-d39fe868b890" providerId="ADAL" clId="{2D556389-9772-485A-A270-672B54D2387D}" dt="2022-04-02T03:28:06.795" v="2" actId="12789"/>
          <ac:graphicFrameMkLst>
            <pc:docMk/>
            <pc:sldMk cId="3791221629" sldId="276"/>
            <ac:graphicFrameMk id="3" creationId="{9007C350-3D30-4932-AE02-1FB7A951D317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1A385-943A-4282-A83A-70BA0E4B2AE0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CA78F-E82A-4E77-A049-6C7C09A8C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944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1A385-943A-4282-A83A-70BA0E4B2AE0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CA78F-E82A-4E77-A049-6C7C09A8C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698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1A385-943A-4282-A83A-70BA0E4B2AE0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CA78F-E82A-4E77-A049-6C7C09A8C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363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1A385-943A-4282-A83A-70BA0E4B2AE0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CA78F-E82A-4E77-A049-6C7C09A8C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186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1A385-943A-4282-A83A-70BA0E4B2AE0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CA78F-E82A-4E77-A049-6C7C09A8C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271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1A385-943A-4282-A83A-70BA0E4B2AE0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CA78F-E82A-4E77-A049-6C7C09A8C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6882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1A385-943A-4282-A83A-70BA0E4B2AE0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CA78F-E82A-4E77-A049-6C7C09A8C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989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1A385-943A-4282-A83A-70BA0E4B2AE0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CA78F-E82A-4E77-A049-6C7C09A8C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157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1A385-943A-4282-A83A-70BA0E4B2AE0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CA78F-E82A-4E77-A049-6C7C09A8C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226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1A385-943A-4282-A83A-70BA0E4B2AE0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CA78F-E82A-4E77-A049-6C7C09A8C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5381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1A385-943A-4282-A83A-70BA0E4B2AE0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CA78F-E82A-4E77-A049-6C7C09A8C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9580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F1A385-943A-4282-A83A-70BA0E4B2AE0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3CA78F-E82A-4E77-A049-6C7C09A8C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9104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Relationship Id="rId9" Type="http://schemas.openxmlformats.org/officeDocument/2006/relationships/image" Target="../media/image18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169A85E-FAA9-4D7D-888A-87444D776F51}"/>
              </a:ext>
            </a:extLst>
          </p:cNvPr>
          <p:cNvSpPr txBox="1"/>
          <p:nvPr/>
        </p:nvSpPr>
        <p:spPr>
          <a:xfrm>
            <a:off x="415793" y="3426614"/>
            <a:ext cx="5970720" cy="269860"/>
          </a:xfrm>
          <a:prstGeom prst="rect">
            <a:avLst/>
          </a:prstGeom>
          <a:noFill/>
        </p:spPr>
        <p:txBody>
          <a:bodyPr wrap="square" lIns="84371" tIns="42185" rIns="84371" bIns="42185" rtlCol="0" anchor="ctr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1. Melanoma cell line phenotypes and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APKi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sensitivitie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C844E56-A648-43E9-AE9B-B23BB1012533}"/>
              </a:ext>
            </a:extLst>
          </p:cNvPr>
          <p:cNvSpPr txBox="1"/>
          <p:nvPr/>
        </p:nvSpPr>
        <p:spPr>
          <a:xfrm>
            <a:off x="415791" y="5431209"/>
            <a:ext cx="3599617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D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	Effective Dose 50 as determined by the MTT assay</a:t>
            </a:r>
          </a:p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	Not sensitive; ED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ould not be determined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	1 ≤ 2-fold MFI increase vs IgG control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	2 ≤ 3-fold MFI increase vs IgG control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*	3 ≤ 4-fold MFI increase vs IgG control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**	4 ≤ 5-fold MFI increase vs IgG control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*** 	&gt; 5-fold MFI increase vs IgG control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9007C350-3D30-4932-AE02-1FB7A951D31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0539581"/>
              </p:ext>
            </p:extLst>
          </p:nvPr>
        </p:nvGraphicFramePr>
        <p:xfrm>
          <a:off x="471488" y="3795261"/>
          <a:ext cx="5915024" cy="1531172"/>
        </p:xfrm>
        <a:graphic>
          <a:graphicData uri="http://schemas.openxmlformats.org/drawingml/2006/table">
            <a:tbl>
              <a:tblPr/>
              <a:tblGrid>
                <a:gridCol w="739378">
                  <a:extLst>
                    <a:ext uri="{9D8B030D-6E8A-4147-A177-3AD203B41FA5}">
                      <a16:colId xmlns:a16="http://schemas.microsoft.com/office/drawing/2014/main" val="441729020"/>
                    </a:ext>
                  </a:extLst>
                </a:gridCol>
                <a:gridCol w="739378">
                  <a:extLst>
                    <a:ext uri="{9D8B030D-6E8A-4147-A177-3AD203B41FA5}">
                      <a16:colId xmlns:a16="http://schemas.microsoft.com/office/drawing/2014/main" val="1889066898"/>
                    </a:ext>
                  </a:extLst>
                </a:gridCol>
                <a:gridCol w="739378">
                  <a:extLst>
                    <a:ext uri="{9D8B030D-6E8A-4147-A177-3AD203B41FA5}">
                      <a16:colId xmlns:a16="http://schemas.microsoft.com/office/drawing/2014/main" val="4068962497"/>
                    </a:ext>
                  </a:extLst>
                </a:gridCol>
                <a:gridCol w="739378">
                  <a:extLst>
                    <a:ext uri="{9D8B030D-6E8A-4147-A177-3AD203B41FA5}">
                      <a16:colId xmlns:a16="http://schemas.microsoft.com/office/drawing/2014/main" val="2224380600"/>
                    </a:ext>
                  </a:extLst>
                </a:gridCol>
                <a:gridCol w="739378">
                  <a:extLst>
                    <a:ext uri="{9D8B030D-6E8A-4147-A177-3AD203B41FA5}">
                      <a16:colId xmlns:a16="http://schemas.microsoft.com/office/drawing/2014/main" val="1481854104"/>
                    </a:ext>
                  </a:extLst>
                </a:gridCol>
                <a:gridCol w="739378">
                  <a:extLst>
                    <a:ext uri="{9D8B030D-6E8A-4147-A177-3AD203B41FA5}">
                      <a16:colId xmlns:a16="http://schemas.microsoft.com/office/drawing/2014/main" val="819060295"/>
                    </a:ext>
                  </a:extLst>
                </a:gridCol>
                <a:gridCol w="739378">
                  <a:extLst>
                    <a:ext uri="{9D8B030D-6E8A-4147-A177-3AD203B41FA5}">
                      <a16:colId xmlns:a16="http://schemas.microsoft.com/office/drawing/2014/main" val="1777478035"/>
                    </a:ext>
                  </a:extLst>
                </a:gridCol>
                <a:gridCol w="739378">
                  <a:extLst>
                    <a:ext uri="{9D8B030D-6E8A-4147-A177-3AD203B41FA5}">
                      <a16:colId xmlns:a16="http://schemas.microsoft.com/office/drawing/2014/main" val="351293793"/>
                    </a:ext>
                  </a:extLst>
                </a:gridCol>
              </a:tblGrid>
              <a:tr h="1903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AFV</a:t>
                      </a:r>
                      <a:r>
                        <a:rPr lang="en-US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0E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status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lative marker expression levels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D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[µM]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69595086"/>
                  </a:ext>
                </a:extLst>
              </a:tr>
              <a:tr h="1738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line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R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CS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NFR1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NFR2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271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AFi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Ki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2077849"/>
                  </a:ext>
                </a:extLst>
              </a:tr>
              <a:tr h="1655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375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8277" marR="8277" marT="827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8650334"/>
                  </a:ext>
                </a:extLst>
              </a:tr>
              <a:tr h="1655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21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8277" marR="8277" marT="827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</a:t>
                      </a:r>
                    </a:p>
                  </a:txBody>
                  <a:tcPr marL="8277" marR="8277" marT="827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3737248"/>
                  </a:ext>
                </a:extLst>
              </a:tr>
              <a:tr h="1655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255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8277" marR="8277" marT="827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8277" marR="8277" marT="827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1932892"/>
                  </a:ext>
                </a:extLst>
              </a:tr>
              <a:tr h="1655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308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</a:t>
                      </a:r>
                    </a:p>
                  </a:txBody>
                  <a:tcPr marL="8277" marR="8277" marT="827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8277" marR="8277" marT="827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419536"/>
                  </a:ext>
                </a:extLst>
              </a:tr>
              <a:tr h="1655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526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.S.</a:t>
                      </a:r>
                    </a:p>
                  </a:txBody>
                  <a:tcPr marL="8277" marR="8277" marT="827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</a:t>
                      </a:r>
                    </a:p>
                  </a:txBody>
                  <a:tcPr marL="8277" marR="8277" marT="827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6476539"/>
                  </a:ext>
                </a:extLst>
              </a:tr>
              <a:tr h="1655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K-Mel-28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8277" marR="8277" marT="827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</a:t>
                      </a:r>
                    </a:p>
                  </a:txBody>
                  <a:tcPr marL="8277" marR="8277" marT="827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6873913"/>
                  </a:ext>
                </a:extLst>
              </a:tr>
              <a:tr h="1738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K-Mel-37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</a:t>
                      </a:r>
                    </a:p>
                  </a:txBody>
                  <a:tcPr marL="8277" marR="8277" marT="82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*</a:t>
                      </a:r>
                    </a:p>
                  </a:txBody>
                  <a:tcPr marL="8277" marR="8277" marT="82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8277" marR="8277" marT="827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8277" marR="8277" marT="827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142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912216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40A0241-DE6C-4B95-AC6E-142230BA60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8027124"/>
              </p:ext>
            </p:extLst>
          </p:nvPr>
        </p:nvGraphicFramePr>
        <p:xfrm>
          <a:off x="272957" y="1472800"/>
          <a:ext cx="6312087" cy="6198400"/>
        </p:xfrm>
        <a:graphic>
          <a:graphicData uri="http://schemas.openxmlformats.org/drawingml/2006/table">
            <a:tbl>
              <a:tblPr/>
              <a:tblGrid>
                <a:gridCol w="461191">
                  <a:extLst>
                    <a:ext uri="{9D8B030D-6E8A-4147-A177-3AD203B41FA5}">
                      <a16:colId xmlns:a16="http://schemas.microsoft.com/office/drawing/2014/main" val="844965411"/>
                    </a:ext>
                  </a:extLst>
                </a:gridCol>
                <a:gridCol w="389816">
                  <a:extLst>
                    <a:ext uri="{9D8B030D-6E8A-4147-A177-3AD203B41FA5}">
                      <a16:colId xmlns:a16="http://schemas.microsoft.com/office/drawing/2014/main" val="1867355104"/>
                    </a:ext>
                  </a:extLst>
                </a:gridCol>
                <a:gridCol w="477662">
                  <a:extLst>
                    <a:ext uri="{9D8B030D-6E8A-4147-A177-3AD203B41FA5}">
                      <a16:colId xmlns:a16="http://schemas.microsoft.com/office/drawing/2014/main" val="3743270085"/>
                    </a:ext>
                  </a:extLst>
                </a:gridCol>
                <a:gridCol w="812573">
                  <a:extLst>
                    <a:ext uri="{9D8B030D-6E8A-4147-A177-3AD203B41FA5}">
                      <a16:colId xmlns:a16="http://schemas.microsoft.com/office/drawing/2014/main" val="3719516241"/>
                    </a:ext>
                  </a:extLst>
                </a:gridCol>
                <a:gridCol w="1048659">
                  <a:extLst>
                    <a:ext uri="{9D8B030D-6E8A-4147-A177-3AD203B41FA5}">
                      <a16:colId xmlns:a16="http://schemas.microsoft.com/office/drawing/2014/main" val="21937109"/>
                    </a:ext>
                  </a:extLst>
                </a:gridCol>
                <a:gridCol w="1046829">
                  <a:extLst>
                    <a:ext uri="{9D8B030D-6E8A-4147-A177-3AD203B41FA5}">
                      <a16:colId xmlns:a16="http://schemas.microsoft.com/office/drawing/2014/main" val="4137767631"/>
                    </a:ext>
                  </a:extLst>
                </a:gridCol>
                <a:gridCol w="521583">
                  <a:extLst>
                    <a:ext uri="{9D8B030D-6E8A-4147-A177-3AD203B41FA5}">
                      <a16:colId xmlns:a16="http://schemas.microsoft.com/office/drawing/2014/main" val="2371885937"/>
                    </a:ext>
                  </a:extLst>
                </a:gridCol>
                <a:gridCol w="499622">
                  <a:extLst>
                    <a:ext uri="{9D8B030D-6E8A-4147-A177-3AD203B41FA5}">
                      <a16:colId xmlns:a16="http://schemas.microsoft.com/office/drawing/2014/main" val="257332605"/>
                    </a:ext>
                  </a:extLst>
                </a:gridCol>
                <a:gridCol w="351384">
                  <a:extLst>
                    <a:ext uri="{9D8B030D-6E8A-4147-A177-3AD203B41FA5}">
                      <a16:colId xmlns:a16="http://schemas.microsoft.com/office/drawing/2014/main" val="3108138968"/>
                    </a:ext>
                  </a:extLst>
                </a:gridCol>
                <a:gridCol w="344064">
                  <a:extLst>
                    <a:ext uri="{9D8B030D-6E8A-4147-A177-3AD203B41FA5}">
                      <a16:colId xmlns:a16="http://schemas.microsoft.com/office/drawing/2014/main" val="700030318"/>
                    </a:ext>
                  </a:extLst>
                </a:gridCol>
                <a:gridCol w="358704">
                  <a:extLst>
                    <a:ext uri="{9D8B030D-6E8A-4147-A177-3AD203B41FA5}">
                      <a16:colId xmlns:a16="http://schemas.microsoft.com/office/drawing/2014/main" val="831452890"/>
                    </a:ext>
                  </a:extLst>
                </a:gridCol>
              </a:tblGrid>
              <a:tr h="922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tient #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der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ge at dx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sease stage dx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x pre Bx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x site(s)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CC IRB#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sponse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tu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271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NFR2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5047643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1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A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pi, Pemb, MEKi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all bowel mesentery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6-099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ive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9446183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2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C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ght axillary LN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6-099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ive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2604546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3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ne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xillary LN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96-099</a:t>
                      </a:r>
                      <a:endParaRPr kumimoji="0" 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ive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7772065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4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FN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eft inguinal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96-099</a:t>
                      </a:r>
                      <a:endParaRPr kumimoji="0" 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ive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0715828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5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C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FN, Rad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all intestine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96-099</a:t>
                      </a:r>
                      <a:endParaRPr kumimoji="0" 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ive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7976291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6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A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FN, Pemb, Ipi, BRAFi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eft axillary mas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96-099</a:t>
                      </a:r>
                      <a:endParaRPr kumimoji="0" 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ive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4494161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7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V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L2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lon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96-099</a:t>
                      </a:r>
                      <a:endParaRPr kumimoji="0" 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ive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3473869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8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A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ft tissue thigh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96-099</a:t>
                      </a:r>
                      <a:endParaRPr kumimoji="0" 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ive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2668857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9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7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C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FN, BRAFi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eft lower leg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96-099</a:t>
                      </a:r>
                      <a:endParaRPr kumimoji="0" 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ive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0527230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10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V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ght axillary LN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96-099</a:t>
                      </a:r>
                      <a:endParaRPr kumimoji="0" 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ive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5271600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11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C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ght axillary mas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96-099</a:t>
                      </a:r>
                      <a:endParaRPr kumimoji="0" 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0030548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12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ght axilla LN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96-099</a:t>
                      </a:r>
                      <a:endParaRPr kumimoji="0" 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3486051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13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A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pi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ght neck mas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96-099</a:t>
                      </a:r>
                      <a:endParaRPr kumimoji="0" 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7078608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14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5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C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pi, BRAFi + MEKi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kin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96-099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2098577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15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m,  Pemb, Ipi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ght groin mas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96-099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1036578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16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7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V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seline: left medial leg;   Wk. 3: left medial thigh;             Wk. 16: left leg soft tissue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-107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4816139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17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A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pi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seline: s.c. post trunk;  Wk.9: left chest wall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-107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D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ive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8706441"/>
                  </a:ext>
                </a:extLst>
              </a:tr>
              <a:tr h="2635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 18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A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L2, Afli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seline: post trunk;           Wk. 3: right back;                  Wk. 7: right chin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-107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18358"/>
                  </a:ext>
                </a:extLst>
              </a:tr>
              <a:tr h="878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libercept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li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7372677"/>
                  </a:ext>
                </a:extLst>
              </a:tr>
              <a:tr h="878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ased to breathe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231139"/>
                  </a:ext>
                </a:extLst>
              </a:tr>
              <a:tr h="878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x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agnosis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3563452"/>
                  </a:ext>
                </a:extLst>
              </a:tr>
              <a:tr h="87847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CC# 12-107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murafenib + high-dose IFN</a:t>
                      </a:r>
                      <a:r>
                        <a:rPr lang="el-G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α</a:t>
                      </a:r>
                      <a:r>
                        <a:rPr lang="el-G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ial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5754605"/>
                  </a:ext>
                </a:extLst>
              </a:tr>
              <a:tr h="878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FN</a:t>
                      </a:r>
                      <a:r>
                        <a:rPr lang="el-G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α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FN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4332565"/>
                  </a:ext>
                </a:extLst>
              </a:tr>
              <a:tr h="878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L-2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L2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152528"/>
                  </a:ext>
                </a:extLst>
              </a:tr>
              <a:tr h="878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pilimuma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pi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1566491"/>
                  </a:ext>
                </a:extLst>
              </a:tr>
              <a:tr h="87847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mbrolizuma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m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105507"/>
                  </a:ext>
                </a:extLst>
              </a:tr>
              <a:tr h="87847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murafenib, Dabarafeni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AFi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6163523"/>
                  </a:ext>
                </a:extLst>
              </a:tr>
              <a:tr h="878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metinib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Ki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8580813"/>
                  </a:ext>
                </a:extLst>
              </a:tr>
              <a:tr h="878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x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</a:t>
                      </a: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92" marR="4392" marT="43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7639641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1CEF565C-FF71-4CCF-91A1-BAEAE3857D13}"/>
              </a:ext>
            </a:extLst>
          </p:cNvPr>
          <p:cNvSpPr txBox="1"/>
          <p:nvPr/>
        </p:nvSpPr>
        <p:spPr>
          <a:xfrm>
            <a:off x="272958" y="1079891"/>
            <a:ext cx="6312086" cy="269860"/>
          </a:xfrm>
          <a:prstGeom prst="rect">
            <a:avLst/>
          </a:prstGeom>
          <a:noFill/>
        </p:spPr>
        <p:txBody>
          <a:bodyPr wrap="square" lIns="84371" tIns="42185" rIns="84371" bIns="42185" rtlCol="0" anchor="ctr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2. Melanoma patient characteristics</a:t>
            </a:r>
          </a:p>
        </p:txBody>
      </p:sp>
    </p:spTree>
    <p:extLst>
      <p:ext uri="{BB962C8B-B14F-4D97-AF65-F5344CB8AC3E}">
        <p14:creationId xmlns:p14="http://schemas.microsoft.com/office/powerpoint/2010/main" val="26346006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703A0EA3-1B7E-415F-8527-FC6FC45EE7E2}"/>
              </a:ext>
            </a:extLst>
          </p:cNvPr>
          <p:cNvSpPr/>
          <p:nvPr/>
        </p:nvSpPr>
        <p:spPr>
          <a:xfrm>
            <a:off x="299600" y="7772400"/>
            <a:ext cx="6258800" cy="639192"/>
          </a:xfrm>
          <a:prstGeom prst="rect">
            <a:avLst/>
          </a:prstGeom>
        </p:spPr>
        <p:txBody>
          <a:bodyPr wrap="square" lIns="84371" tIns="42185" rIns="84371" bIns="42185">
            <a:spAutoFit/>
          </a:bodyPr>
          <a:lstStyle/>
          <a:p>
            <a:pPr algn="just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altLang="ko-KR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i="1" dirty="0">
                <a:solidFill>
                  <a:prstClr val="black"/>
                </a:solidFill>
                <a:latin typeface="Arial" charset="0"/>
              </a:rPr>
              <a:t>BRAF</a:t>
            </a:r>
            <a:r>
              <a:rPr lang="en-US" sz="1200" b="1" i="1" baseline="30000" dirty="0">
                <a:solidFill>
                  <a:prstClr val="black"/>
                </a:solidFill>
                <a:latin typeface="Arial" charset="0"/>
              </a:rPr>
              <a:t>V600E+</a:t>
            </a:r>
            <a:r>
              <a:rPr lang="en-US" sz="1200" b="1" i="1" dirty="0">
                <a:solidFill>
                  <a:prstClr val="black"/>
                </a:solidFill>
                <a:latin typeface="Arial" charset="0"/>
              </a:rPr>
              <a:t> melanoma cell lines express various levels of mutant BRAF protein</a:t>
            </a:r>
            <a:r>
              <a:rPr lang="en-US" sz="1200" b="1" dirty="0">
                <a:solidFill>
                  <a:prstClr val="black"/>
                </a:solidFill>
                <a:latin typeface="Arial" charset="0"/>
              </a:rPr>
              <a:t>. </a:t>
            </a:r>
            <a:r>
              <a:rPr lang="en-US" sz="1200" dirty="0">
                <a:solidFill>
                  <a:prstClr val="black"/>
                </a:solidFill>
                <a:latin typeface="Arial" charset="0"/>
              </a:rPr>
              <a:t>PCR-generated 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en-US" sz="12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600E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utation status of 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uman m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anoma cell lines utilized in this study was confirmed by</a:t>
            </a: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ow cytometry (BRAF</a:t>
            </a:r>
            <a:r>
              <a:rPr lang="en-US" altLang="ko-KR" sz="12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600E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tibody VE1; Roche). </a:t>
            </a:r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7101BC3F-7A71-4767-B1A1-812A11D89055}"/>
              </a:ext>
            </a:extLst>
          </p:cNvPr>
          <p:cNvGrpSpPr/>
          <p:nvPr/>
        </p:nvGrpSpPr>
        <p:grpSpPr>
          <a:xfrm>
            <a:off x="1371600" y="3268837"/>
            <a:ext cx="4257675" cy="2606326"/>
            <a:chOff x="1371600" y="4315968"/>
            <a:chExt cx="4257675" cy="2606326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64FAEDC7-4F22-4B24-AF6E-AF6E4723A689}"/>
                </a:ext>
              </a:extLst>
            </p:cNvPr>
            <p:cNvSpPr txBox="1"/>
            <p:nvPr/>
          </p:nvSpPr>
          <p:spPr>
            <a:xfrm>
              <a:off x="1955021" y="4315968"/>
              <a:ext cx="9541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Mel526</a:t>
              </a:r>
            </a:p>
          </p:txBody>
        </p:sp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B36E2BA2-7645-4B64-A352-996703B9396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71600" y="4572000"/>
              <a:ext cx="1971675" cy="2350294"/>
            </a:xfrm>
            <a:prstGeom prst="rect">
              <a:avLst/>
            </a:prstGeom>
          </p:spPr>
        </p:pic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8BF9D692-EF31-46D3-A594-3E83118B48D8}"/>
                </a:ext>
              </a:extLst>
            </p:cNvPr>
            <p:cNvGrpSpPr/>
            <p:nvPr/>
          </p:nvGrpSpPr>
          <p:grpSpPr>
            <a:xfrm>
              <a:off x="3657600" y="4315968"/>
              <a:ext cx="1971675" cy="2606326"/>
              <a:chOff x="4185362" y="4315968"/>
              <a:chExt cx="1971675" cy="2606326"/>
            </a:xfrm>
          </p:grpSpPr>
          <p:pic>
            <p:nvPicPr>
              <p:cNvPr id="30" name="Picture 29">
                <a:extLst>
                  <a:ext uri="{FF2B5EF4-FFF2-40B4-BE49-F238E27FC236}">
                    <a16:creationId xmlns:a16="http://schemas.microsoft.com/office/drawing/2014/main" id="{5B79302B-C313-401A-994D-A26FBDDBCE4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185362" y="4572000"/>
                <a:ext cx="1971675" cy="2350294"/>
              </a:xfrm>
              <a:prstGeom prst="rect">
                <a:avLst/>
              </a:prstGeom>
            </p:spPr>
          </p:pic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3A6D80DB-ED70-4FE0-9B8C-96C49745EA38}"/>
                  </a:ext>
                </a:extLst>
              </p:cNvPr>
              <p:cNvSpPr txBox="1"/>
              <p:nvPr/>
            </p:nvSpPr>
            <p:spPr>
              <a:xfrm>
                <a:off x="4585965" y="4315968"/>
                <a:ext cx="130035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K-Mel-28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255343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7">
            <a:extLst>
              <a:ext uri="{FF2B5EF4-FFF2-40B4-BE49-F238E27FC236}">
                <a16:creationId xmlns:a16="http://schemas.microsoft.com/office/drawing/2014/main" id="{8670AEA0-CF4E-47CA-86FB-4C5A10725090}"/>
              </a:ext>
            </a:extLst>
          </p:cNvPr>
          <p:cNvSpPr/>
          <p:nvPr/>
        </p:nvSpPr>
        <p:spPr>
          <a:xfrm>
            <a:off x="241663" y="7772400"/>
            <a:ext cx="637467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2. Correlation of TNFR1, TNFR2 and CD271 expression levels on </a:t>
            </a:r>
            <a:r>
              <a:rPr lang="en-US" sz="1200" b="1" i="1" dirty="0">
                <a:solidFill>
                  <a:prstClr val="black"/>
                </a:solidFill>
                <a:latin typeface="Arial" charset="0"/>
              </a:rPr>
              <a:t>BRAF</a:t>
            </a:r>
            <a:r>
              <a:rPr lang="en-US" sz="1200" b="1" i="1" baseline="30000" dirty="0">
                <a:solidFill>
                  <a:prstClr val="black"/>
                </a:solidFill>
                <a:latin typeface="Arial" charset="0"/>
              </a:rPr>
              <a:t>V600E+</a:t>
            </a:r>
            <a:r>
              <a:rPr lang="en-US" sz="1200" b="1" i="1" dirty="0">
                <a:solidFill>
                  <a:prstClr val="black"/>
                </a:solidFill>
                <a:latin typeface="Arial" charset="0"/>
              </a:rPr>
              <a:t> melanoma cell lines</a:t>
            </a:r>
            <a:r>
              <a:rPr lang="en-US" altLang="ko-KR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xpression levels of the three receptors adjusted for respective IgG controls (</a:t>
            </a: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1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were evaluated by linear correlation. </a:t>
            </a:r>
            <a:endParaRPr lang="en-US" sz="1200" dirty="0"/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420F9E0A-485D-429F-BB60-7388D0B739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8880" y="2350008"/>
            <a:ext cx="2033587" cy="2220278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5868E5ED-0987-4D8E-A350-6491B21F5B2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200" y="2351722"/>
            <a:ext cx="2033587" cy="2220278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55CF9BA6-6511-483B-B157-8EE52D964BE2}"/>
              </a:ext>
            </a:extLst>
          </p:cNvPr>
          <p:cNvGrpSpPr/>
          <p:nvPr/>
        </p:nvGrpSpPr>
        <p:grpSpPr>
          <a:xfrm>
            <a:off x="4480560" y="2351722"/>
            <a:ext cx="1996166" cy="2220278"/>
            <a:chOff x="3545343" y="2351722"/>
            <a:chExt cx="1996166" cy="2220278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E79CC2B4-FDDF-4690-80C1-C19EEEF8223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707946" y="2351722"/>
              <a:ext cx="1833563" cy="2220278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1107848-DC30-4B68-820A-A14D63C3D171}"/>
                </a:ext>
              </a:extLst>
            </p:cNvPr>
            <p:cNvSpPr txBox="1"/>
            <p:nvPr/>
          </p:nvSpPr>
          <p:spPr>
            <a:xfrm rot="16200000">
              <a:off x="3153247" y="3037503"/>
              <a:ext cx="1053495" cy="2693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50" b="1" dirty="0">
                  <a:latin typeface="Arial" panose="020B0604020202020204" pitchFamily="34" charset="0"/>
                  <a:cs typeface="Arial" panose="020B0604020202020204" pitchFamily="34" charset="0"/>
                </a:rPr>
                <a:t>TNFR2 (MFI)</a:t>
              </a: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C24AC17D-067A-42A5-8206-16D415208630}"/>
              </a:ext>
            </a:extLst>
          </p:cNvPr>
          <p:cNvGrpSpPr/>
          <p:nvPr/>
        </p:nvGrpSpPr>
        <p:grpSpPr>
          <a:xfrm>
            <a:off x="3412333" y="4711953"/>
            <a:ext cx="920789" cy="1182430"/>
            <a:chOff x="3412333" y="4711953"/>
            <a:chExt cx="920789" cy="1182430"/>
          </a:xfrm>
        </p:grpSpPr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D4130D8E-9304-477F-A93C-4697396F533E}"/>
                </a:ext>
              </a:extLst>
            </p:cNvPr>
            <p:cNvSpPr/>
            <p:nvPr/>
          </p:nvSpPr>
          <p:spPr>
            <a:xfrm>
              <a:off x="3412333" y="4711953"/>
              <a:ext cx="904122" cy="116955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ED99E7E2-ECB6-48E7-9B86-3D782C65BAF6}"/>
                </a:ext>
              </a:extLst>
            </p:cNvPr>
            <p:cNvGrpSpPr/>
            <p:nvPr/>
          </p:nvGrpSpPr>
          <p:grpSpPr>
            <a:xfrm>
              <a:off x="3485673" y="4724832"/>
              <a:ext cx="847449" cy="1169551"/>
              <a:chOff x="3485673" y="4724832"/>
              <a:chExt cx="847449" cy="1169551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0BCD3E6F-0468-483C-9FD8-16E79E551800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485673" y="4805884"/>
                <a:ext cx="88919" cy="984392"/>
                <a:chOff x="5270159" y="1523895"/>
                <a:chExt cx="63415" cy="702033"/>
              </a:xfrm>
            </p:grpSpPr>
            <p:sp>
              <p:nvSpPr>
                <p:cNvPr id="22" name="Oval 21">
                  <a:extLst>
                    <a:ext uri="{FF2B5EF4-FFF2-40B4-BE49-F238E27FC236}">
                      <a16:creationId xmlns:a16="http://schemas.microsoft.com/office/drawing/2014/main" id="{EDCBBF25-F53E-4913-BB84-59DC9FD5CDB0}"/>
                    </a:ext>
                  </a:extLst>
                </p:cNvPr>
                <p:cNvSpPr/>
                <p:nvPr/>
              </p:nvSpPr>
              <p:spPr>
                <a:xfrm>
                  <a:off x="5270159" y="2054888"/>
                  <a:ext cx="63415" cy="63416"/>
                </a:xfrm>
                <a:prstGeom prst="ellipse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23" name="Rectangle 22">
                  <a:extLst>
                    <a:ext uri="{FF2B5EF4-FFF2-40B4-BE49-F238E27FC236}">
                      <a16:creationId xmlns:a16="http://schemas.microsoft.com/office/drawing/2014/main" id="{69BF0ED9-387A-480E-BADA-CF04AFA992F8}"/>
                    </a:ext>
                  </a:extLst>
                </p:cNvPr>
                <p:cNvSpPr/>
                <p:nvPr/>
              </p:nvSpPr>
              <p:spPr>
                <a:xfrm>
                  <a:off x="5270159" y="1844969"/>
                  <a:ext cx="63415" cy="63416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24" name="Diamond 23">
                  <a:extLst>
                    <a:ext uri="{FF2B5EF4-FFF2-40B4-BE49-F238E27FC236}">
                      <a16:creationId xmlns:a16="http://schemas.microsoft.com/office/drawing/2014/main" id="{BDA40F1B-F486-47E0-B86C-B75611AAE4B0}"/>
                    </a:ext>
                  </a:extLst>
                </p:cNvPr>
                <p:cNvSpPr/>
                <p:nvPr/>
              </p:nvSpPr>
              <p:spPr>
                <a:xfrm>
                  <a:off x="5270159" y="1949979"/>
                  <a:ext cx="63415" cy="63416"/>
                </a:xfrm>
                <a:prstGeom prst="diamond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25" name="Isosceles Triangle 24">
                  <a:extLst>
                    <a:ext uri="{FF2B5EF4-FFF2-40B4-BE49-F238E27FC236}">
                      <a16:creationId xmlns:a16="http://schemas.microsoft.com/office/drawing/2014/main" id="{B530E8A6-CED6-4211-A594-351D5695BD9E}"/>
                    </a:ext>
                  </a:extLst>
                </p:cNvPr>
                <p:cNvSpPr/>
                <p:nvPr/>
              </p:nvSpPr>
              <p:spPr>
                <a:xfrm flipV="1">
                  <a:off x="5270159" y="2162512"/>
                  <a:ext cx="63415" cy="63416"/>
                </a:xfrm>
                <a:prstGeom prst="triangle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26" name="Rectangle 25">
                  <a:extLst>
                    <a:ext uri="{FF2B5EF4-FFF2-40B4-BE49-F238E27FC236}">
                      <a16:creationId xmlns:a16="http://schemas.microsoft.com/office/drawing/2014/main" id="{9AC19987-F263-48E0-AD9D-493BB251B496}"/>
                    </a:ext>
                  </a:extLst>
                </p:cNvPr>
                <p:cNvSpPr/>
                <p:nvPr/>
              </p:nvSpPr>
              <p:spPr>
                <a:xfrm>
                  <a:off x="5270159" y="1628905"/>
                  <a:ext cx="63415" cy="6341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27" name="Oval 26">
                  <a:extLst>
                    <a:ext uri="{FF2B5EF4-FFF2-40B4-BE49-F238E27FC236}">
                      <a16:creationId xmlns:a16="http://schemas.microsoft.com/office/drawing/2014/main" id="{626A3A20-4470-49DB-BDB7-EDEB7FB376EA}"/>
                    </a:ext>
                  </a:extLst>
                </p:cNvPr>
                <p:cNvSpPr/>
                <p:nvPr/>
              </p:nvSpPr>
              <p:spPr>
                <a:xfrm>
                  <a:off x="5270159" y="1737301"/>
                  <a:ext cx="63415" cy="63416"/>
                </a:xfrm>
                <a:prstGeom prst="ellipse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28" name="Diamond 27">
                  <a:extLst>
                    <a:ext uri="{FF2B5EF4-FFF2-40B4-BE49-F238E27FC236}">
                      <a16:creationId xmlns:a16="http://schemas.microsoft.com/office/drawing/2014/main" id="{EB0B5F2C-F011-471E-9E7C-91EFA6748DC3}"/>
                    </a:ext>
                  </a:extLst>
                </p:cNvPr>
                <p:cNvSpPr/>
                <p:nvPr/>
              </p:nvSpPr>
              <p:spPr>
                <a:xfrm>
                  <a:off x="5270159" y="1523895"/>
                  <a:ext cx="63415" cy="63416"/>
                </a:xfrm>
                <a:prstGeom prst="diamond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</p:grp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8D00BEE3-B0A0-455C-AA23-7C9AB47D1645}"/>
                  </a:ext>
                </a:extLst>
              </p:cNvPr>
              <p:cNvSpPr txBox="1"/>
              <p:nvPr/>
            </p:nvSpPr>
            <p:spPr>
              <a:xfrm>
                <a:off x="3544124" y="4724832"/>
                <a:ext cx="788998" cy="1169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el526</a:t>
                </a:r>
              </a:p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308</a:t>
                </a:r>
              </a:p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K-Mel-28</a:t>
                </a:r>
              </a:p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K-Mel-37</a:t>
                </a:r>
              </a:p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375</a:t>
                </a:r>
              </a:p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21</a:t>
                </a:r>
              </a:p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255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0028790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4AE210C-7E5D-40F0-A57E-0FDEBC04D3C7}"/>
              </a:ext>
            </a:extLst>
          </p:cNvPr>
          <p:cNvGrpSpPr>
            <a:grpSpLocks noChangeAspect="1"/>
          </p:cNvGrpSpPr>
          <p:nvPr/>
        </p:nvGrpSpPr>
        <p:grpSpPr>
          <a:xfrm>
            <a:off x="2188305" y="2837893"/>
            <a:ext cx="1111464" cy="3224084"/>
            <a:chOff x="2286000" y="914400"/>
            <a:chExt cx="1709738" cy="495953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4EA0B01-FE4C-457B-985A-3A6AC43F9D3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86000" y="914400"/>
              <a:ext cx="1709738" cy="184785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0EF2E8FB-001C-4457-BFBF-17C095FAE82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286000" y="2470240"/>
              <a:ext cx="1709738" cy="184785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9A77679-BF90-4469-9E96-1F253108441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86000" y="4026080"/>
              <a:ext cx="1709738" cy="1847850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5010E293-84B8-4E40-82E8-B32C37D3DF19}"/>
              </a:ext>
            </a:extLst>
          </p:cNvPr>
          <p:cNvSpPr txBox="1"/>
          <p:nvPr/>
        </p:nvSpPr>
        <p:spPr>
          <a:xfrm>
            <a:off x="1993380" y="2615966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8FD4C54F-8AA9-45C2-8204-EB4AE91B8D6E}"/>
              </a:ext>
            </a:extLst>
          </p:cNvPr>
          <p:cNvGrpSpPr/>
          <p:nvPr/>
        </p:nvGrpSpPr>
        <p:grpSpPr>
          <a:xfrm>
            <a:off x="3323865" y="2938204"/>
            <a:ext cx="1166223" cy="3478829"/>
            <a:chOff x="12804661" y="25680552"/>
            <a:chExt cx="1793972" cy="5351397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58B42AD3-78BE-4253-9AF9-7A210EF3D07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2804661" y="25680552"/>
              <a:ext cx="1788821" cy="205178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5C5F3642-3B40-4960-843E-0D190DF43F5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2809812" y="27791190"/>
              <a:ext cx="1788821" cy="3240759"/>
            </a:xfrm>
            <a:prstGeom prst="rect">
              <a:avLst/>
            </a:prstGeom>
          </p:spPr>
        </p:pic>
      </p:grpSp>
      <p:sp>
        <p:nvSpPr>
          <p:cNvPr id="10" name="Rectangle 9">
            <a:extLst>
              <a:ext uri="{FF2B5EF4-FFF2-40B4-BE49-F238E27FC236}">
                <a16:creationId xmlns:a16="http://schemas.microsoft.com/office/drawing/2014/main" id="{FE3CF860-2BCE-4E6A-90A1-030CDBBDD462}"/>
              </a:ext>
            </a:extLst>
          </p:cNvPr>
          <p:cNvSpPr/>
          <p:nvPr/>
        </p:nvSpPr>
        <p:spPr>
          <a:xfrm>
            <a:off x="241663" y="7625598"/>
            <a:ext cx="637467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3. Generation and activation of monocyte-derived macrophages</a:t>
            </a: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Human monocyte-derived macrophage (M</a:t>
            </a:r>
            <a:r>
              <a:rPr lang="el-GR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phenotype was confirmed by </a:t>
            </a: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low cytometry (CD14</a:t>
            </a:r>
            <a:r>
              <a:rPr lang="en-US" altLang="ko-KR" sz="12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68</a:t>
            </a:r>
            <a:r>
              <a:rPr lang="en-US" altLang="ko-KR" sz="12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0</a:t>
            </a:r>
            <a:r>
              <a:rPr lang="en-US" altLang="ko-KR" sz="12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6</a:t>
            </a:r>
            <a:r>
              <a:rPr lang="en-US" altLang="ko-KR" sz="12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heir ability to release solTNF and VEGF in response to LPS + IFN</a:t>
            </a:r>
            <a:r>
              <a:rPr lang="el-GR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ctivation. </a:t>
            </a:r>
            <a:endParaRPr lang="en-US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93BCCFC-71CC-42D1-820B-E12BEE3F161F}"/>
              </a:ext>
            </a:extLst>
          </p:cNvPr>
          <p:cNvSpPr txBox="1"/>
          <p:nvPr/>
        </p:nvSpPr>
        <p:spPr>
          <a:xfrm>
            <a:off x="3323865" y="2668616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5477144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69E42DEF-E6C7-4458-BD91-799AD3CFF7DA}"/>
              </a:ext>
            </a:extLst>
          </p:cNvPr>
          <p:cNvGrpSpPr>
            <a:grpSpLocks noChangeAspect="1"/>
          </p:cNvGrpSpPr>
          <p:nvPr/>
        </p:nvGrpSpPr>
        <p:grpSpPr>
          <a:xfrm>
            <a:off x="472383" y="3648643"/>
            <a:ext cx="2849887" cy="1887430"/>
            <a:chOff x="1189971" y="699252"/>
            <a:chExt cx="4749819" cy="314571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04EF44D-DBE2-46D5-A564-E8F85C5D67A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572000" y="699252"/>
              <a:ext cx="1367790" cy="147828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D5ECD27-F708-4FB9-B7D5-AACA5186340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200400" y="699252"/>
              <a:ext cx="1367790" cy="147828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A2A8CAEF-48D8-42B2-B2C3-DEE0067C932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828800" y="699252"/>
              <a:ext cx="1367790" cy="147828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7F60F7C-5D17-4849-9B1C-25348C3DCCB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828800" y="2366688"/>
              <a:ext cx="1367790" cy="147828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89FE745C-F1DB-4293-84EF-EB40F670053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200400" y="2366688"/>
              <a:ext cx="1367790" cy="147828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793598C5-D4C2-47F1-A2D6-3E2DAAB37F2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572000" y="2366688"/>
              <a:ext cx="1367790" cy="1478280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FCAA299-6E43-455E-B95D-96DA68ECAE42}"/>
                </a:ext>
              </a:extLst>
            </p:cNvPr>
            <p:cNvSpPr txBox="1"/>
            <p:nvPr/>
          </p:nvSpPr>
          <p:spPr>
            <a:xfrm>
              <a:off x="1189971" y="1185700"/>
              <a:ext cx="780665" cy="4103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el1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A94D093-1975-4D01-AD41-C26BDDAFCBFE}"/>
                </a:ext>
              </a:extLst>
            </p:cNvPr>
            <p:cNvSpPr txBox="1"/>
            <p:nvPr/>
          </p:nvSpPr>
          <p:spPr>
            <a:xfrm>
              <a:off x="1189971" y="2840152"/>
              <a:ext cx="780665" cy="4103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el2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833571A2-49D0-47AF-B0B1-7F3E7C491710}"/>
              </a:ext>
            </a:extLst>
          </p:cNvPr>
          <p:cNvSpPr txBox="1"/>
          <p:nvPr/>
        </p:nvSpPr>
        <p:spPr>
          <a:xfrm>
            <a:off x="4232080" y="3648644"/>
            <a:ext cx="420884" cy="2215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el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A8B00CC-1F9E-4F37-9AAB-C858CC42D287}"/>
              </a:ext>
            </a:extLst>
          </p:cNvPr>
          <p:cNvSpPr txBox="1"/>
          <p:nvPr/>
        </p:nvSpPr>
        <p:spPr>
          <a:xfrm>
            <a:off x="5601751" y="3648643"/>
            <a:ext cx="420885" cy="2215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el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065A2B6-132E-4975-8CB3-CD86C34F29C1}"/>
              </a:ext>
            </a:extLst>
          </p:cNvPr>
          <p:cNvSpPr txBox="1"/>
          <p:nvPr/>
        </p:nvSpPr>
        <p:spPr>
          <a:xfrm>
            <a:off x="363557" y="3374323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6501272-D2D6-4D92-A0D7-4D706A1E5674}"/>
              </a:ext>
            </a:extLst>
          </p:cNvPr>
          <p:cNvSpPr txBox="1"/>
          <p:nvPr/>
        </p:nvSpPr>
        <p:spPr>
          <a:xfrm>
            <a:off x="3486882" y="3374323"/>
            <a:ext cx="3970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68852E6E-46E3-42CD-A6AB-ADC046764EB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66744" y="3767328"/>
            <a:ext cx="1249680" cy="2005584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3964B8FC-7957-474D-BF19-9E03A821ABF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059994" y="3795280"/>
            <a:ext cx="1828800" cy="2029968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BBC918E2-A55F-401B-9079-4E05737121F4}"/>
              </a:ext>
            </a:extLst>
          </p:cNvPr>
          <p:cNvSpPr/>
          <p:nvPr/>
        </p:nvSpPr>
        <p:spPr>
          <a:xfrm>
            <a:off x="241663" y="7625598"/>
            <a:ext cx="637467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4. TNFR2</a:t>
            </a:r>
            <a:r>
              <a:rPr lang="en-US" altLang="ko-KR" sz="1200" b="1" i="1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imary BRAF</a:t>
            </a:r>
            <a:r>
              <a:rPr lang="en-US" altLang="ko-KR" sz="1200" b="1" i="1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600E+</a:t>
            </a:r>
            <a:r>
              <a:rPr lang="en-US" altLang="ko-KR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lanoma cell line can acquire resistance to </a:t>
            </a:r>
            <a:r>
              <a:rPr lang="en-US" altLang="ko-KR" sz="1200" b="1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AFi</a:t>
            </a:r>
            <a:r>
              <a:rPr lang="en-US" altLang="ko-KR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response to </a:t>
            </a:r>
            <a:r>
              <a:rPr lang="en-US" altLang="ko-KR" sz="1200" b="1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lTNF</a:t>
            </a:r>
            <a:r>
              <a:rPr lang="en-US" altLang="ko-KR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reatment</a:t>
            </a: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imary melanoma cell lines were generated from two BRAF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600E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elanoma patient biopsies. Their TNFR1, TNFR2 and CD271 profiles were evaluated by flow cytometry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arly passage cell lines (10 passages or less) cultured in the presence or absence of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olTNF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ere tested for their sensitivity to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AF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K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mediated cytotoxicity. Data shown represent mean values of quadruplicate tests and whiskers represent standard error. * p ≤ 0.0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33776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D433092E-3C36-D31A-0DC3-E4DFB116964B}"/>
              </a:ext>
            </a:extLst>
          </p:cNvPr>
          <p:cNvSpPr/>
          <p:nvPr/>
        </p:nvSpPr>
        <p:spPr>
          <a:xfrm>
            <a:off x="241663" y="7625598"/>
            <a:ext cx="637467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5. TNFR2 expression on BRAF</a:t>
            </a:r>
            <a:r>
              <a:rPr lang="en-US" altLang="ko-KR" sz="1200" b="1" i="1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600E+</a:t>
            </a:r>
            <a:r>
              <a:rPr lang="en-US" altLang="ko-KR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lanoma is upregulated in response to IFN-</a:t>
            </a:r>
            <a:r>
              <a:rPr lang="el-GR" altLang="ko-KR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ko-KR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but not </a:t>
            </a:r>
            <a:r>
              <a:rPr lang="en-US" altLang="ko-KR" sz="1200" b="1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PKi</a:t>
            </a: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K-Mel-28 cell line was cultured for 48 h in the presence or absence of IFN-</a:t>
            </a:r>
            <a:r>
              <a:rPr lang="el-GR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γ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1000 IU/ml), 0.5 µM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AF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0.5 µM) and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K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0.2 µM). Subsequently, cells were collected and stained for TNFR2 by 2-step staining as previously described. Data shown are representative of three independent experiment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43942C8B-15B2-BB35-F4D8-E96365FA32DC}"/>
              </a:ext>
            </a:extLst>
          </p:cNvPr>
          <p:cNvGrpSpPr/>
          <p:nvPr/>
        </p:nvGrpSpPr>
        <p:grpSpPr>
          <a:xfrm>
            <a:off x="1645652" y="2691765"/>
            <a:ext cx="3566696" cy="3760470"/>
            <a:chOff x="2227409" y="1329753"/>
            <a:chExt cx="3566696" cy="376047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2BB577A-4810-242C-01B7-E3C6E438732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27409" y="1329753"/>
              <a:ext cx="1737360" cy="1880235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C8B2A65-053A-E19E-20B5-F213BA99F9B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227409" y="3209988"/>
              <a:ext cx="1737360" cy="1880235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7E1EEAA2-FAEB-4174-D65F-AFFCFB3CD50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026086" y="3209988"/>
              <a:ext cx="1737360" cy="1880235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E95C5F9D-0014-9D49-F4C9-93934309452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026086" y="1329753"/>
              <a:ext cx="1737360" cy="1880235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481BA3C-C957-BBF7-7809-D69C7984DD95}"/>
                </a:ext>
              </a:extLst>
            </p:cNvPr>
            <p:cNvSpPr txBox="1"/>
            <p:nvPr/>
          </p:nvSpPr>
          <p:spPr>
            <a:xfrm>
              <a:off x="3094218" y="1459345"/>
              <a:ext cx="9012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Untreated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918E451-01E5-C640-C765-398144F190CF}"/>
                </a:ext>
              </a:extLst>
            </p:cNvPr>
            <p:cNvSpPr txBox="1"/>
            <p:nvPr/>
          </p:nvSpPr>
          <p:spPr>
            <a:xfrm>
              <a:off x="5224718" y="1459344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10F711F-278A-DC3A-08C8-6BD0016F8B73}"/>
                </a:ext>
              </a:extLst>
            </p:cNvPr>
            <p:cNvSpPr txBox="1"/>
            <p:nvPr/>
          </p:nvSpPr>
          <p:spPr>
            <a:xfrm>
              <a:off x="3341081" y="3339580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RAFi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AAA08DC-0433-719B-C331-3E7D038EA111}"/>
                </a:ext>
              </a:extLst>
            </p:cNvPr>
            <p:cNvSpPr txBox="1"/>
            <p:nvPr/>
          </p:nvSpPr>
          <p:spPr>
            <a:xfrm>
              <a:off x="5224718" y="3339579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EKi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116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F5484B8C691E44DA3DAC9BBC48C48F8" ma:contentTypeVersion="12" ma:contentTypeDescription="Create a new document." ma:contentTypeScope="" ma:versionID="7c35857cf2449c086a3f21dbdd8055ae">
  <xsd:schema xmlns:xsd="http://www.w3.org/2001/XMLSchema" xmlns:xs="http://www.w3.org/2001/XMLSchema" xmlns:p="http://schemas.microsoft.com/office/2006/metadata/properties" xmlns:ns3="4560b02a-e85d-49d1-97f7-239b725f2179" xmlns:ns4="5b9fd263-dad0-4aa8-bece-c2f9e81fff2d" targetNamespace="http://schemas.microsoft.com/office/2006/metadata/properties" ma:root="true" ma:fieldsID="290e30174229eaa77f73a0a6e971fe6c" ns3:_="" ns4:_="">
    <xsd:import namespace="4560b02a-e85d-49d1-97f7-239b725f2179"/>
    <xsd:import namespace="5b9fd263-dad0-4aa8-bece-c2f9e81fff2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560b02a-e85d-49d1-97f7-239b725f217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b9fd263-dad0-4aa8-bece-c2f9e81fff2d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A97EEE50-F892-49DE-B3FF-D22350C4FB6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B64B7F3-2A22-484C-BC4D-41A46201FEE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560b02a-e85d-49d1-97f7-239b725f2179"/>
    <ds:schemaRef ds:uri="5b9fd263-dad0-4aa8-bece-c2f9e81fff2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D991FE6E-1CFA-437D-911C-C3E7F5149CC4}">
  <ds:schemaRefs>
    <ds:schemaRef ds:uri="http://purl.org/dc/elements/1.1/"/>
    <ds:schemaRef ds:uri="http://schemas.microsoft.com/office/2006/documentManagement/types"/>
    <ds:schemaRef ds:uri="5b9fd263-dad0-4aa8-bece-c2f9e81fff2d"/>
    <ds:schemaRef ds:uri="4560b02a-e85d-49d1-97f7-239b725f2179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schemas.microsoft.com/office/2006/metadata/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51</TotalTime>
  <Words>890</Words>
  <Application>Microsoft Office PowerPoint</Application>
  <PresentationFormat>On-screen Show (4:3)</PresentationFormat>
  <Paragraphs>335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ki</dc:creator>
  <cp:lastModifiedBy>Vujanovic, Lazar Nikola</cp:lastModifiedBy>
  <cp:revision>106</cp:revision>
  <dcterms:created xsi:type="dcterms:W3CDTF">2019-03-10T01:49:50Z</dcterms:created>
  <dcterms:modified xsi:type="dcterms:W3CDTF">2022-07-14T00:38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F5484B8C691E44DA3DAC9BBC48C48F8</vt:lpwstr>
  </property>
</Properties>
</file>